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810" r:id="rId2"/>
    <p:sldId id="257" r:id="rId3"/>
    <p:sldId id="260" r:id="rId4"/>
    <p:sldId id="258" r:id="rId5"/>
    <p:sldId id="259" r:id="rId6"/>
  </p:sldIdLst>
  <p:sldSz cx="12192000" cy="6858000"/>
  <p:notesSz cx="6858000" cy="9144000"/>
  <p:defaultTextStyle>
    <a:defPPr>
      <a:defRPr lang="ja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110"/>
    <p:restoredTop sz="94678"/>
  </p:normalViewPr>
  <p:slideViewPr>
    <p:cSldViewPr snapToGrid="0">
      <p:cViewPr varScale="1">
        <p:scale>
          <a:sx n="106" d="100"/>
          <a:sy n="106" d="100"/>
        </p:scale>
        <p:origin x="7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US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CD5358-C15A-5C4A-BB8E-D20D197FBE73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US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US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US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3665AC-EA68-CB4B-883A-E415BFF9A63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692361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F2CAC74-CC9B-4C91-53B1-1D67D3AB19A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4B90AE08-D08B-407A-2515-D1A0FBEA003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C9C311B4-8640-5CB4-4838-A3897CA41032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US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2D969E3-52DA-BF7C-2D9A-01781423354B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F827024-858F-A641-8EA2-1D7FDB035CF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0053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C51055-74AA-17D5-79A1-F3E60B0A4E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US" altLang="en-US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E4E5F9E-F5ED-4357-8A35-3E5BC9D4035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  <a:endParaRPr kumimoji="1" lang="ja-US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DD2BC16-1238-C9C9-DD92-34F1F28459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467F96-E3D9-9D07-856F-B097303FD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F203AB-76C8-BE7D-4CB9-445393F43C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62338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7083301-937E-CD7A-2D2C-C7EEBD6F43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US" alt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967BB0C-75B7-0F52-5D97-9286899262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US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9F2A46C-7C4F-AB2A-0C4E-249DC23693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D17FC7-733F-1476-0966-38A23A0B8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857E2A7-E180-41A1-BE4E-3CC2A65DF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2307574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96929CD-C9FE-7857-DEA5-BC1D1D1C05D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  <a:endParaRPr kumimoji="1" lang="ja-US" altLang="en-US"/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44E86C2-D9CD-DE05-860C-EA96E64E30F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US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C000508-F29D-C972-5F65-4471B4E70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904C76D-A130-2A74-F2C8-A8688F33D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2730F92-DBEA-67C0-A9A4-C8E1FC5F4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41108558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1E24D1B-3A5E-85A6-468C-D63BA0707F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US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EA4484C-356B-DC1E-73D9-C15826ADD8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US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7171C2-2037-CCE1-3C1D-7635746753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D32EC7C-C7E1-834F-5320-6F59A1475F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74395D2-4CCD-B97C-0CAB-EF13DA725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0394358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56CF50E-A562-AEC6-1BDB-AF9B59349D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US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E151140-8D05-1A27-92B4-561E12802B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329BD2-163E-E2DF-8110-2C1BEE354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37D2184-4ABA-A7C5-6199-EACE145B1D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C646D0D-B48B-0601-43A0-60C8CD774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944702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7D2747F-ABAF-14AC-10CB-ED8CC6B4ED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US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15F75D8-AFFE-71A4-CFB6-9FC8018DCC7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US" altLang="en-US"/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52C341D-536D-0BC0-F434-D900C5155C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US" altLang="en-US"/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343D00C-4937-AC15-0323-57D6A5BFC3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77866C52-1D6F-9430-7091-FD7F8739C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0B3F540-12BF-A11C-2D33-7A8B8E5593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439614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A1056A8-CF23-B467-B84E-895EC994C9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US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099E6AF-E9D3-282F-18AF-0F55647FA5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13D60E0-E9A8-A1AD-7249-022364422A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US" altLang="en-US"/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E654C41-AFFD-A7CA-0F19-2F0E79F4E3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C8C6117-F20B-5F5F-3233-37A0A1ED55E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US" altLang="en-US"/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0CE73758-F8F7-EACA-1C02-75603F5A8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27337AC-7667-3CA2-5E53-D720DAD574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7EAA056-3DA4-821B-652A-A97D2EB0FF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977868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70CA41E-C62C-6927-16C9-C0C8F700B8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  <a:endParaRPr kumimoji="1" lang="ja-US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0532116-5D9E-13C3-CE74-21F5370F9F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331B4FE-FD7B-D013-2977-331F9FD8ED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E4B0E0A-1811-00F3-15F9-D0DDCCFA8F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0037067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E5CC569-196A-BFC0-26B9-6D78BD91EB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6B42EA3-258E-00C1-55BB-8C1B11AE45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21ED596-85B0-36BF-483A-35D4BA4CFB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20370567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60911E3-FF25-C349-4F31-174F0F1FEE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US" altLang="en-US"/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58502D9-4546-4FEF-E48F-B9102D25645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US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7D06704-522C-17F4-2F17-E6943D7815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8ECE8B-0EFE-BF08-47D5-78532C4297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D83159D-430D-21B6-A4BD-6D04764EB7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3D9E66C-6AFC-4027-E233-D9FACB7BAD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322815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9FB9B5-E1CE-D6DF-C90F-FAFA57ACF9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  <a:endParaRPr kumimoji="1" lang="ja-US" altLang="en-US"/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2FB44A6-F880-9119-AFFA-B6BDBC5F11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US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0A380718-35FE-D0DE-235C-41F2BB6EAD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F78920A-F859-8EB1-7591-79EF21DE9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36A39D7-F3DE-A47C-1E62-03D8C98A3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C195847-0631-83B4-5AC5-514111F1F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4253872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9498BA1-6A85-2C23-8AF7-4B436A1D9D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  <a:endParaRPr kumimoji="1" lang="ja-US" altLang="en-US"/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46C8D87-3265-A5B5-A9F1-817C52BBD1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  <a:endParaRPr kumimoji="1" lang="ja-US" altLang="en-US"/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42BA8A2-0317-E64B-C2ED-3094163605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FF92D62-5845-1440-A3CA-F349E34779A2}" type="datetimeFigureOut">
              <a:rPr kumimoji="1" lang="ja-US" altLang="en-US" smtClean="0"/>
              <a:t>01/12/2026</a:t>
            </a:fld>
            <a:endParaRPr kumimoji="1" lang="ja-US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F961851-DFD7-AB01-8CB6-961E4D0CAE1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US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C60E810-8D79-4A98-73BE-5265EF2068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164C1BA-E68A-B24D-A52F-7C3D5C668E7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2684100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tif"/><Relationship Id="rId4" Type="http://schemas.openxmlformats.org/officeDocument/2006/relationships/image" Target="../media/image12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"/><Relationship Id="rId2" Type="http://schemas.openxmlformats.org/officeDocument/2006/relationships/image" Target="../media/image14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AB18330-36D1-7345-F9F1-5B4F407D38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9079AC6-A16E-2AD6-D19E-40C8F122F8D3}"/>
              </a:ext>
            </a:extLst>
          </p:cNvPr>
          <p:cNvSpPr txBox="1"/>
          <p:nvPr/>
        </p:nvSpPr>
        <p:spPr>
          <a:xfrm>
            <a:off x="2633496" y="-11166"/>
            <a:ext cx="781653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24" b="1" dirty="0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5589F28-F979-1EE7-477C-61E278579A6D}"/>
              </a:ext>
            </a:extLst>
          </p:cNvPr>
          <p:cNvSpPr txBox="1"/>
          <p:nvPr/>
        </p:nvSpPr>
        <p:spPr>
          <a:xfrm>
            <a:off x="5393652" y="-12584"/>
            <a:ext cx="781653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24" b="1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3FD8784-70B4-95F4-CE7E-AEE73DF589D9}"/>
              </a:ext>
            </a:extLst>
          </p:cNvPr>
          <p:cNvSpPr txBox="1"/>
          <p:nvPr/>
        </p:nvSpPr>
        <p:spPr>
          <a:xfrm>
            <a:off x="8650836" y="7280861"/>
            <a:ext cx="636489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100x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65E2C7F-CCF9-BD23-24A0-5BB5F98542D4}"/>
              </a:ext>
            </a:extLst>
          </p:cNvPr>
          <p:cNvSpPr txBox="1"/>
          <p:nvPr/>
        </p:nvSpPr>
        <p:spPr>
          <a:xfrm>
            <a:off x="13185097" y="7280861"/>
            <a:ext cx="636489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33" dirty="0"/>
              <a:t>400x</a:t>
            </a: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44D3BAD-8B58-23A7-13E4-628173D1890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83318" y="0"/>
            <a:ext cx="2864525" cy="2568195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927F372C-EF61-9404-710D-05CC03AB8E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12684" y="0"/>
            <a:ext cx="4012317" cy="2568195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361DA18-8819-9265-72E9-62DFB617EC92}"/>
              </a:ext>
            </a:extLst>
          </p:cNvPr>
          <p:cNvSpPr txBox="1"/>
          <p:nvPr/>
        </p:nvSpPr>
        <p:spPr>
          <a:xfrm>
            <a:off x="2080675" y="5179214"/>
            <a:ext cx="818925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b="1" dirty="0">
                <a:latin typeface="Palatino Linotype" panose="02040502050505030304" pitchFamily="18" charset="0"/>
              </a:rPr>
              <a:t>Supplementary Figure S1. </a:t>
            </a:r>
            <a:r>
              <a:rPr lang="en-US" altLang="ja-US" sz="14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alysis of CDK11B expression across pediatric kidney tumors. (A) </a:t>
            </a:r>
            <a:r>
              <a:rPr lang="en-US" altLang="ja-US" sz="14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DK11B expression levels in RTK, Wilms tumor (WT), and clear cell sarcoma of the kidney (CCSK) obtained from the TARGET-PANCAN dataset. </a:t>
            </a:r>
            <a:r>
              <a:rPr lang="en-US" altLang="ja-US" sz="14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B)</a:t>
            </a:r>
            <a:r>
              <a:rPr lang="en-US" altLang="ja-US" sz="14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verall survival of WT patients stratified by CDK11B expression (Median survival CDK11B high: 564 days, CDK11B low: 672 days). CDK11B expression levels are shown as RSEM-normalized values.</a:t>
            </a:r>
            <a:r>
              <a:rPr lang="en-US" altLang="ja-US" sz="1400" b="1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C)</a:t>
            </a:r>
            <a:r>
              <a:rPr lang="en-US" altLang="ja-US" sz="1400" dirty="0"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verall survival of WT patients stratified by CDK11B expression (Median survival CDK11B high: 858 days, CDK11B low: 1379 days). </a:t>
            </a:r>
            <a:endParaRPr kumimoji="1" lang="ja-US" altLang="en-US" sz="1400" dirty="0"/>
          </a:p>
        </p:txBody>
      </p:sp>
      <p:sp>
        <p:nvSpPr>
          <p:cNvPr id="5" name="TextBox 2">
            <a:extLst>
              <a:ext uri="{FF2B5EF4-FFF2-40B4-BE49-F238E27FC236}">
                <a16:creationId xmlns:a16="http://schemas.microsoft.com/office/drawing/2014/main" id="{1C7C4FCD-B96B-BF13-EE43-724B4C454ECB}"/>
              </a:ext>
            </a:extLst>
          </p:cNvPr>
          <p:cNvSpPr txBox="1"/>
          <p:nvPr/>
        </p:nvSpPr>
        <p:spPr>
          <a:xfrm>
            <a:off x="2633495" y="2414953"/>
            <a:ext cx="781653" cy="32688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24" b="1" dirty="0"/>
              <a:t>C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7FB7E96-B956-BD3E-CC27-D18A89268C87}"/>
              </a:ext>
            </a:extLst>
          </p:cNvPr>
          <p:cNvSpPr txBox="1"/>
          <p:nvPr/>
        </p:nvSpPr>
        <p:spPr>
          <a:xfrm>
            <a:off x="7280862" y="-10200"/>
            <a:ext cx="781625" cy="2974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333" b="1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kumimoji="1" lang="ja-US" altLang="en-US" sz="1333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C03B95AA-033C-CF27-23BD-1FB956CE0A6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683318" y="2578395"/>
            <a:ext cx="3625768" cy="22486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61873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861CFAD-2CD4-39E2-2710-C73091604C67}"/>
              </a:ext>
            </a:extLst>
          </p:cNvPr>
          <p:cNvSpPr txBox="1"/>
          <p:nvPr/>
        </p:nvSpPr>
        <p:spPr>
          <a:xfrm>
            <a:off x="66486" y="6376777"/>
            <a:ext cx="939558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kumimoji="1" lang="en-US" altLang="ja-US" sz="1400" b="1" dirty="0">
                <a:latin typeface="Palatino Linotype" panose="02040502050505030304" pitchFamily="18" charset="0"/>
              </a:rPr>
              <a:t>Supplementary Figure S2. </a:t>
            </a:r>
            <a:r>
              <a:rPr lang="en-US" altLang="ja-US" sz="1400" b="1" dirty="0">
                <a:effectLst/>
                <a:latin typeface="Palatino Linotype" panose="02040502050505030304" pitchFamily="18" charset="0"/>
              </a:rPr>
              <a:t>Uncropped Western blots corresponding to Figure 2A.</a:t>
            </a: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3BB29C8-D62C-A26B-2432-FF7BC9FD3755}"/>
              </a:ext>
            </a:extLst>
          </p:cNvPr>
          <p:cNvSpPr txBox="1"/>
          <p:nvPr/>
        </p:nvSpPr>
        <p:spPr>
          <a:xfrm>
            <a:off x="42162" y="1291895"/>
            <a:ext cx="1639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u="sng" dirty="0"/>
              <a:t>Figure 2A</a:t>
            </a:r>
            <a:endParaRPr kumimoji="1" lang="ja-US" altLang="en-US" b="1" u="sng" dirty="0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CC1CCAF9-DE6C-9FE1-337C-6CA5C63D00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463" y="1825254"/>
            <a:ext cx="3909803" cy="2738881"/>
          </a:xfrm>
          <a:prstGeom prst="rect">
            <a:avLst/>
          </a:prstGeom>
          <a:ln w="12700">
            <a:noFill/>
          </a:ln>
        </p:spPr>
      </p:pic>
      <p:pic>
        <p:nvPicPr>
          <p:cNvPr id="15" name="図 14" descr="コンピュータ, 部屋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155D2A95-649A-47D8-B922-9A908C2A692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241655" y="1825254"/>
            <a:ext cx="3909803" cy="2738881"/>
          </a:xfrm>
          <a:prstGeom prst="rect">
            <a:avLst/>
          </a:prstGeom>
          <a:ln>
            <a:noFill/>
          </a:ln>
        </p:spPr>
      </p:pic>
      <p:pic>
        <p:nvPicPr>
          <p:cNvPr id="17" name="図 16" descr="白黒の写真&#10;&#10;AI 生成コンテンツは誤りを含む可能性があります。">
            <a:extLst>
              <a:ext uri="{FF2B5EF4-FFF2-40B4-BE49-F238E27FC236}">
                <a16:creationId xmlns:a16="http://schemas.microsoft.com/office/drawing/2014/main" id="{FA99D6FF-DF82-8941-F472-035E09A043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13059" y="1825254"/>
            <a:ext cx="3909803" cy="2738881"/>
          </a:xfrm>
          <a:prstGeom prst="rect">
            <a:avLst/>
          </a:prstGeom>
          <a:ln>
            <a:noFill/>
          </a:ln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4E0D14D9-019B-B8DD-C1B9-E0582F327E52}"/>
              </a:ext>
            </a:extLst>
          </p:cNvPr>
          <p:cNvSpPr txBox="1"/>
          <p:nvPr/>
        </p:nvSpPr>
        <p:spPr>
          <a:xfrm>
            <a:off x="1053605" y="3945673"/>
            <a:ext cx="323507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Whole PARP (116 </a:t>
            </a:r>
            <a:r>
              <a:rPr kumimoji="1" lang="en-US" altLang="ja-US" b="1" dirty="0" err="1"/>
              <a:t>kDa</a:t>
            </a:r>
            <a:r>
              <a:rPr kumimoji="1" lang="en-US" altLang="ja-US" b="1" dirty="0"/>
              <a:t>)</a:t>
            </a:r>
          </a:p>
          <a:p>
            <a:r>
              <a:rPr kumimoji="1" lang="en-US" altLang="ja-US" b="1" dirty="0"/>
              <a:t>Cleaved PARP (89 </a:t>
            </a:r>
            <a:r>
              <a:rPr kumimoji="1" lang="en-US" altLang="ja-US" b="1" dirty="0" err="1"/>
              <a:t>kDa</a:t>
            </a:r>
            <a:r>
              <a:rPr kumimoji="1" lang="en-US" altLang="ja-US" b="1" dirty="0"/>
              <a:t>)</a:t>
            </a:r>
            <a:endParaRPr kumimoji="1" lang="ja-US" altLang="en-US" b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FB624E1A-5A3C-4AC9-518A-F9D3C79D3A25}"/>
              </a:ext>
            </a:extLst>
          </p:cNvPr>
          <p:cNvSpPr txBox="1"/>
          <p:nvPr/>
        </p:nvSpPr>
        <p:spPr>
          <a:xfrm>
            <a:off x="4489831" y="4222672"/>
            <a:ext cx="403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Cleaved Caspase-3 (17, 19 </a:t>
            </a:r>
            <a:r>
              <a:rPr kumimoji="1" lang="en-US" altLang="ja-US" b="1" dirty="0" err="1"/>
              <a:t>kDa</a:t>
            </a:r>
            <a:r>
              <a:rPr kumimoji="1" lang="en-US" altLang="ja-US" b="1" dirty="0"/>
              <a:t>)</a:t>
            </a:r>
            <a:endParaRPr kumimoji="1" lang="ja-US" altLang="en-US" b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7F96FF9-F327-136D-09A6-98919FA2DE1D}"/>
              </a:ext>
            </a:extLst>
          </p:cNvPr>
          <p:cNvSpPr txBox="1"/>
          <p:nvPr/>
        </p:nvSpPr>
        <p:spPr>
          <a:xfrm>
            <a:off x="9437751" y="4194803"/>
            <a:ext cx="32350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Actin (43 </a:t>
            </a:r>
            <a:r>
              <a:rPr kumimoji="1" lang="en-US" altLang="ja-US" b="1" dirty="0" err="1"/>
              <a:t>kDa</a:t>
            </a:r>
            <a:r>
              <a:rPr kumimoji="1" lang="en-US" altLang="ja-US" b="1" dirty="0"/>
              <a:t>)</a:t>
            </a:r>
            <a:endParaRPr kumimoji="1" lang="ja-US" altLang="en-US" b="1" dirty="0"/>
          </a:p>
        </p:txBody>
      </p:sp>
      <p:cxnSp>
        <p:nvCxnSpPr>
          <p:cNvPr id="3" name="直線コネクタ 2">
            <a:extLst>
              <a:ext uri="{FF2B5EF4-FFF2-40B4-BE49-F238E27FC236}">
                <a16:creationId xmlns:a16="http://schemas.microsoft.com/office/drawing/2014/main" id="{D9650594-2D40-A265-4FD6-8B9ADF19822A}"/>
              </a:ext>
            </a:extLst>
          </p:cNvPr>
          <p:cNvCxnSpPr/>
          <p:nvPr/>
        </p:nvCxnSpPr>
        <p:spPr>
          <a:xfrm>
            <a:off x="584200" y="2984500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EFE5FEA8-5C58-C272-AF91-1B00B4914510}"/>
              </a:ext>
            </a:extLst>
          </p:cNvPr>
          <p:cNvCxnSpPr/>
          <p:nvPr/>
        </p:nvCxnSpPr>
        <p:spPr>
          <a:xfrm>
            <a:off x="584200" y="3086100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F220A6C0-6B4E-97C9-E6EC-31267C8C6870}"/>
              </a:ext>
            </a:extLst>
          </p:cNvPr>
          <p:cNvCxnSpPr/>
          <p:nvPr/>
        </p:nvCxnSpPr>
        <p:spPr>
          <a:xfrm>
            <a:off x="584200" y="3213100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20B4ACBC-9271-8153-DF7E-10096E9C0B29}"/>
              </a:ext>
            </a:extLst>
          </p:cNvPr>
          <p:cNvCxnSpPr/>
          <p:nvPr/>
        </p:nvCxnSpPr>
        <p:spPr>
          <a:xfrm>
            <a:off x="584200" y="3327400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0899E82-877D-11ED-9936-8230C1C4B28B}"/>
              </a:ext>
            </a:extLst>
          </p:cNvPr>
          <p:cNvSpPr txBox="1"/>
          <p:nvPr/>
        </p:nvSpPr>
        <p:spPr>
          <a:xfrm>
            <a:off x="312649" y="2536770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 err="1"/>
              <a:t>kDa</a:t>
            </a:r>
            <a:endParaRPr kumimoji="1" lang="ja-US" altLang="en-US" sz="14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CAFA43A-F65D-0168-62AC-0963B06C4AB9}"/>
              </a:ext>
            </a:extLst>
          </p:cNvPr>
          <p:cNvSpPr txBox="1"/>
          <p:nvPr/>
        </p:nvSpPr>
        <p:spPr>
          <a:xfrm>
            <a:off x="157136" y="2803724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/>
              <a:t>140</a:t>
            </a:r>
            <a:endParaRPr kumimoji="1" lang="ja-US" altLang="en-US" sz="14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CF1CF4C-BF3D-FBB3-43E5-B52F2E34CB6E}"/>
              </a:ext>
            </a:extLst>
          </p:cNvPr>
          <p:cNvSpPr txBox="1"/>
          <p:nvPr/>
        </p:nvSpPr>
        <p:spPr>
          <a:xfrm>
            <a:off x="162358" y="2944911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/>
              <a:t>100</a:t>
            </a:r>
            <a:endParaRPr kumimoji="1" lang="ja-US" altLang="en-US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BBEDA67-B6E6-DF1A-19E5-6277DCB7E263}"/>
              </a:ext>
            </a:extLst>
          </p:cNvPr>
          <p:cNvSpPr txBox="1"/>
          <p:nvPr/>
        </p:nvSpPr>
        <p:spPr>
          <a:xfrm>
            <a:off x="234455" y="3073399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/>
              <a:t>70</a:t>
            </a:r>
            <a:endParaRPr kumimoji="1" lang="ja-US" altLang="en-US" sz="14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E0278EC-3DBA-603E-7DEA-B5A5D54C2079}"/>
              </a:ext>
            </a:extLst>
          </p:cNvPr>
          <p:cNvSpPr txBox="1"/>
          <p:nvPr/>
        </p:nvSpPr>
        <p:spPr>
          <a:xfrm>
            <a:off x="247155" y="3200400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/>
              <a:t>50</a:t>
            </a:r>
            <a:endParaRPr kumimoji="1" lang="ja-US" altLang="en-US" sz="1400" dirty="0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D9A3FA2F-635F-7B34-0248-BB7981816076}"/>
              </a:ext>
            </a:extLst>
          </p:cNvPr>
          <p:cNvCxnSpPr>
            <a:cxnSpLocks/>
          </p:cNvCxnSpPr>
          <p:nvPr/>
        </p:nvCxnSpPr>
        <p:spPr>
          <a:xfrm>
            <a:off x="1053605" y="2237976"/>
            <a:ext cx="12196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98E6740D-062F-D5AF-EA77-297D87503983}"/>
              </a:ext>
            </a:extLst>
          </p:cNvPr>
          <p:cNvCxnSpPr>
            <a:cxnSpLocks/>
          </p:cNvCxnSpPr>
          <p:nvPr/>
        </p:nvCxnSpPr>
        <p:spPr>
          <a:xfrm>
            <a:off x="2374405" y="2689170"/>
            <a:ext cx="12196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3ED5460-127B-055C-B3F3-603E5BAEF427}"/>
              </a:ext>
            </a:extLst>
          </p:cNvPr>
          <p:cNvSpPr txBox="1"/>
          <p:nvPr/>
        </p:nvSpPr>
        <p:spPr>
          <a:xfrm>
            <a:off x="1106378" y="1856103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Figure 2A </a:t>
            </a:r>
            <a:endParaRPr kumimoji="1" lang="ja-US" altLang="en-US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00C8A92-DF00-4D6F-1DF6-5A5F8B3E8BE3}"/>
              </a:ext>
            </a:extLst>
          </p:cNvPr>
          <p:cNvSpPr txBox="1"/>
          <p:nvPr/>
        </p:nvSpPr>
        <p:spPr>
          <a:xfrm>
            <a:off x="2524769" y="2319838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Unused</a:t>
            </a:r>
            <a:endParaRPr kumimoji="1" lang="ja-US" altLang="en-US" dirty="0"/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8B1F87C1-35DE-6B5D-0A33-3BDE5B0E270B}"/>
              </a:ext>
            </a:extLst>
          </p:cNvPr>
          <p:cNvCxnSpPr>
            <a:cxnSpLocks/>
          </p:cNvCxnSpPr>
          <p:nvPr/>
        </p:nvCxnSpPr>
        <p:spPr>
          <a:xfrm>
            <a:off x="1053605" y="2504504"/>
            <a:ext cx="636234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4BA75EBA-4AFF-DD7F-5C24-BCC0F702C022}"/>
              </a:ext>
            </a:extLst>
          </p:cNvPr>
          <p:cNvCxnSpPr>
            <a:cxnSpLocks/>
          </p:cNvCxnSpPr>
          <p:nvPr/>
        </p:nvCxnSpPr>
        <p:spPr>
          <a:xfrm>
            <a:off x="1738171" y="2504504"/>
            <a:ext cx="636234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B0A7C21-95D9-28ED-A07F-C4BAD78C8DC1}"/>
              </a:ext>
            </a:extLst>
          </p:cNvPr>
          <p:cNvSpPr txBox="1"/>
          <p:nvPr/>
        </p:nvSpPr>
        <p:spPr>
          <a:xfrm>
            <a:off x="1014147" y="2180454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G401</a:t>
            </a:r>
            <a:endParaRPr kumimoji="1" lang="ja-US" altLang="en-US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4D7C2CBC-30FC-45EA-DBD9-68633F3AAF8B}"/>
              </a:ext>
            </a:extLst>
          </p:cNvPr>
          <p:cNvSpPr txBox="1"/>
          <p:nvPr/>
        </p:nvSpPr>
        <p:spPr>
          <a:xfrm>
            <a:off x="1747972" y="2180454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JMU</a:t>
            </a:r>
            <a:endParaRPr kumimoji="1" lang="ja-US" altLang="en-US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644AAB0-2837-E3B9-5375-88335E270339}"/>
              </a:ext>
            </a:extLst>
          </p:cNvPr>
          <p:cNvSpPr txBox="1"/>
          <p:nvPr/>
        </p:nvSpPr>
        <p:spPr>
          <a:xfrm>
            <a:off x="10166205" y="4772130"/>
            <a:ext cx="2442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JMU: JMU-RTK-2</a:t>
            </a:r>
            <a:endParaRPr kumimoji="1" lang="ja-US" altLang="en-US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818BC943-0CFE-C339-AAF3-E160345DFB75}"/>
              </a:ext>
            </a:extLst>
          </p:cNvPr>
          <p:cNvSpPr txBox="1"/>
          <p:nvPr/>
        </p:nvSpPr>
        <p:spPr>
          <a:xfrm>
            <a:off x="10166206" y="5084281"/>
            <a:ext cx="2442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: Control</a:t>
            </a:r>
            <a:endParaRPr kumimoji="1" lang="ja-US" altLang="en-US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7DB8F688-2334-6AFA-1302-6FD2CB5AC4EB}"/>
              </a:ext>
            </a:extLst>
          </p:cNvPr>
          <p:cNvSpPr txBox="1"/>
          <p:nvPr/>
        </p:nvSpPr>
        <p:spPr>
          <a:xfrm>
            <a:off x="10166205" y="5396432"/>
            <a:ext cx="2442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: OTS964</a:t>
            </a:r>
            <a:endParaRPr kumimoji="1" lang="ja-US" altLang="en-US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A1C15F07-C4C1-3465-DCDA-4BA338AA2506}"/>
              </a:ext>
            </a:extLst>
          </p:cNvPr>
          <p:cNvSpPr txBox="1"/>
          <p:nvPr/>
        </p:nvSpPr>
        <p:spPr>
          <a:xfrm>
            <a:off x="1050590" y="2522295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12369FC-4FC1-ACFE-B4A0-0E49E222FBB9}"/>
              </a:ext>
            </a:extLst>
          </p:cNvPr>
          <p:cNvSpPr txBox="1"/>
          <p:nvPr/>
        </p:nvSpPr>
        <p:spPr>
          <a:xfrm>
            <a:off x="1380790" y="2522295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D2699A92-5B97-AACD-AEAA-B7AD14159B6F}"/>
              </a:ext>
            </a:extLst>
          </p:cNvPr>
          <p:cNvSpPr txBox="1"/>
          <p:nvPr/>
        </p:nvSpPr>
        <p:spPr>
          <a:xfrm>
            <a:off x="2028490" y="2509595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B052F12-6C0A-10AF-D320-AC80222B273E}"/>
              </a:ext>
            </a:extLst>
          </p:cNvPr>
          <p:cNvSpPr txBox="1"/>
          <p:nvPr/>
        </p:nvSpPr>
        <p:spPr>
          <a:xfrm>
            <a:off x="1710990" y="2509595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03547338-065E-C376-4B06-1F9DFEAE5279}"/>
              </a:ext>
            </a:extLst>
          </p:cNvPr>
          <p:cNvCxnSpPr/>
          <p:nvPr/>
        </p:nvCxnSpPr>
        <p:spPr>
          <a:xfrm>
            <a:off x="4422186" y="2949004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AC5450A5-7917-0E20-7A3A-ED45BCA2A3DC}"/>
              </a:ext>
            </a:extLst>
          </p:cNvPr>
          <p:cNvCxnSpPr/>
          <p:nvPr/>
        </p:nvCxnSpPr>
        <p:spPr>
          <a:xfrm>
            <a:off x="8578354" y="2657235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189B79C9-C20C-6628-77CC-0CC18AF60F43}"/>
              </a:ext>
            </a:extLst>
          </p:cNvPr>
          <p:cNvCxnSpPr/>
          <p:nvPr/>
        </p:nvCxnSpPr>
        <p:spPr>
          <a:xfrm>
            <a:off x="4422186" y="3533204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02113110-9CCE-7444-8A95-DDD053449B38}"/>
              </a:ext>
            </a:extLst>
          </p:cNvPr>
          <p:cNvCxnSpPr>
            <a:cxnSpLocks/>
          </p:cNvCxnSpPr>
          <p:nvPr/>
        </p:nvCxnSpPr>
        <p:spPr>
          <a:xfrm>
            <a:off x="4891591" y="2278680"/>
            <a:ext cx="12196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41A57EC8-EBA6-475E-D628-D69A31488D7C}"/>
              </a:ext>
            </a:extLst>
          </p:cNvPr>
          <p:cNvCxnSpPr>
            <a:cxnSpLocks/>
          </p:cNvCxnSpPr>
          <p:nvPr/>
        </p:nvCxnSpPr>
        <p:spPr>
          <a:xfrm>
            <a:off x="6297771" y="2844547"/>
            <a:ext cx="12196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389A137D-561F-3B11-A09B-160729F433B5}"/>
              </a:ext>
            </a:extLst>
          </p:cNvPr>
          <p:cNvSpPr txBox="1"/>
          <p:nvPr/>
        </p:nvSpPr>
        <p:spPr>
          <a:xfrm>
            <a:off x="4944364" y="1896807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Figure 2A </a:t>
            </a:r>
            <a:endParaRPr kumimoji="1" lang="ja-US" altLang="en-US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725FD6A-F87A-B220-D6AA-A94D31BF235E}"/>
              </a:ext>
            </a:extLst>
          </p:cNvPr>
          <p:cNvSpPr txBox="1"/>
          <p:nvPr/>
        </p:nvSpPr>
        <p:spPr>
          <a:xfrm>
            <a:off x="6418595" y="2469965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Unused</a:t>
            </a:r>
            <a:endParaRPr kumimoji="1" lang="ja-US" altLang="en-US" dirty="0"/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E9F2CDF0-8BB6-7150-FE94-33B40AA81CE1}"/>
              </a:ext>
            </a:extLst>
          </p:cNvPr>
          <p:cNvCxnSpPr>
            <a:cxnSpLocks/>
          </p:cNvCxnSpPr>
          <p:nvPr/>
        </p:nvCxnSpPr>
        <p:spPr>
          <a:xfrm>
            <a:off x="4891591" y="2545208"/>
            <a:ext cx="636234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69552E26-BADB-57E9-FBDE-F66D590C082F}"/>
              </a:ext>
            </a:extLst>
          </p:cNvPr>
          <p:cNvCxnSpPr>
            <a:cxnSpLocks/>
          </p:cNvCxnSpPr>
          <p:nvPr/>
        </p:nvCxnSpPr>
        <p:spPr>
          <a:xfrm>
            <a:off x="5576157" y="2545208"/>
            <a:ext cx="636234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C1AE8DA9-6689-AB3D-D362-10E68ABAFFF1}"/>
              </a:ext>
            </a:extLst>
          </p:cNvPr>
          <p:cNvSpPr txBox="1"/>
          <p:nvPr/>
        </p:nvSpPr>
        <p:spPr>
          <a:xfrm>
            <a:off x="4852133" y="2221158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G401</a:t>
            </a:r>
            <a:endParaRPr kumimoji="1" lang="ja-US" altLang="en-US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C0FE690B-2B0F-A898-303B-13616E2C577B}"/>
              </a:ext>
            </a:extLst>
          </p:cNvPr>
          <p:cNvSpPr txBox="1"/>
          <p:nvPr/>
        </p:nvSpPr>
        <p:spPr>
          <a:xfrm>
            <a:off x="5585958" y="2221158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JMU</a:t>
            </a:r>
            <a:endParaRPr kumimoji="1" lang="ja-US" altLang="en-US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008093F5-AAA6-7F0E-E577-C6AB88C538F2}"/>
              </a:ext>
            </a:extLst>
          </p:cNvPr>
          <p:cNvSpPr txBox="1"/>
          <p:nvPr/>
        </p:nvSpPr>
        <p:spPr>
          <a:xfrm>
            <a:off x="4888576" y="2562999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217A727F-FD34-1D00-FCAF-3F5503778C74}"/>
              </a:ext>
            </a:extLst>
          </p:cNvPr>
          <p:cNvSpPr txBox="1"/>
          <p:nvPr/>
        </p:nvSpPr>
        <p:spPr>
          <a:xfrm>
            <a:off x="5218776" y="2562999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C478590A-747A-D87D-6195-D7D70ECACDBA}"/>
              </a:ext>
            </a:extLst>
          </p:cNvPr>
          <p:cNvSpPr txBox="1"/>
          <p:nvPr/>
        </p:nvSpPr>
        <p:spPr>
          <a:xfrm>
            <a:off x="5866476" y="2550299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D657023B-6B20-A036-EB87-A54E9D384FD7}"/>
              </a:ext>
            </a:extLst>
          </p:cNvPr>
          <p:cNvSpPr txBox="1"/>
          <p:nvPr/>
        </p:nvSpPr>
        <p:spPr>
          <a:xfrm>
            <a:off x="5548976" y="2550299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63A367A5-5C27-745D-832B-87A5B3CB7C5C}"/>
              </a:ext>
            </a:extLst>
          </p:cNvPr>
          <p:cNvSpPr txBox="1"/>
          <p:nvPr/>
        </p:nvSpPr>
        <p:spPr>
          <a:xfrm>
            <a:off x="8462592" y="2221158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 err="1"/>
              <a:t>kDa</a:t>
            </a:r>
            <a:endParaRPr kumimoji="1" lang="ja-US" altLang="en-US" sz="1400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73FB600C-2C17-6C13-019B-A05D1942468F}"/>
              </a:ext>
            </a:extLst>
          </p:cNvPr>
          <p:cNvSpPr txBox="1"/>
          <p:nvPr/>
        </p:nvSpPr>
        <p:spPr>
          <a:xfrm>
            <a:off x="8271018" y="2514488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/>
              <a:t>40</a:t>
            </a:r>
            <a:endParaRPr kumimoji="1" lang="ja-US" altLang="en-US" sz="1400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46F73F13-8258-D6F2-0796-C0E7C3D8E2D4}"/>
              </a:ext>
            </a:extLst>
          </p:cNvPr>
          <p:cNvSpPr txBox="1"/>
          <p:nvPr/>
        </p:nvSpPr>
        <p:spPr>
          <a:xfrm>
            <a:off x="4183234" y="2545208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 err="1"/>
              <a:t>kDa</a:t>
            </a:r>
            <a:endParaRPr kumimoji="1" lang="ja-US" altLang="en-US" sz="1400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5F26E95C-A3B4-9F68-2814-59BC0ABC2F1E}"/>
              </a:ext>
            </a:extLst>
          </p:cNvPr>
          <p:cNvSpPr txBox="1"/>
          <p:nvPr/>
        </p:nvSpPr>
        <p:spPr>
          <a:xfrm>
            <a:off x="4130709" y="2793458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/>
              <a:t>25</a:t>
            </a:r>
            <a:endParaRPr kumimoji="1" lang="ja-US" altLang="en-US" sz="1400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3EEB8D79-5A3D-69CF-DABF-056878336014}"/>
              </a:ext>
            </a:extLst>
          </p:cNvPr>
          <p:cNvSpPr txBox="1"/>
          <p:nvPr/>
        </p:nvSpPr>
        <p:spPr>
          <a:xfrm>
            <a:off x="4130709" y="3377096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/>
              <a:t>15</a:t>
            </a:r>
            <a:endParaRPr kumimoji="1" lang="ja-US" altLang="en-US" sz="1400" dirty="0"/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607D0419-E150-5D16-D37F-A58EE845AC49}"/>
              </a:ext>
            </a:extLst>
          </p:cNvPr>
          <p:cNvCxnSpPr>
            <a:cxnSpLocks/>
          </p:cNvCxnSpPr>
          <p:nvPr/>
        </p:nvCxnSpPr>
        <p:spPr>
          <a:xfrm>
            <a:off x="8965593" y="1902729"/>
            <a:ext cx="12196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3AEF373D-99F3-5E6C-0713-7B0A88D9D2D2}"/>
              </a:ext>
            </a:extLst>
          </p:cNvPr>
          <p:cNvCxnSpPr>
            <a:cxnSpLocks/>
          </p:cNvCxnSpPr>
          <p:nvPr/>
        </p:nvCxnSpPr>
        <p:spPr>
          <a:xfrm>
            <a:off x="10371773" y="2468596"/>
            <a:ext cx="12196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9BB51CAF-AEC4-E38E-DE24-04F4BF44277C}"/>
              </a:ext>
            </a:extLst>
          </p:cNvPr>
          <p:cNvSpPr txBox="1"/>
          <p:nvPr/>
        </p:nvSpPr>
        <p:spPr>
          <a:xfrm>
            <a:off x="9018366" y="1520856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Figure 2A </a:t>
            </a:r>
            <a:endParaRPr kumimoji="1" lang="ja-US" altLang="en-US" dirty="0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BC3EE205-739E-BE0B-CDC5-2D57FDA74EB3}"/>
              </a:ext>
            </a:extLst>
          </p:cNvPr>
          <p:cNvSpPr txBox="1"/>
          <p:nvPr/>
        </p:nvSpPr>
        <p:spPr>
          <a:xfrm>
            <a:off x="10492597" y="2094014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Unused</a:t>
            </a:r>
            <a:endParaRPr kumimoji="1" lang="ja-US" altLang="en-US" dirty="0"/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0766C8B2-9A41-00DD-CC36-14426DC52F03}"/>
              </a:ext>
            </a:extLst>
          </p:cNvPr>
          <p:cNvCxnSpPr>
            <a:cxnSpLocks/>
          </p:cNvCxnSpPr>
          <p:nvPr/>
        </p:nvCxnSpPr>
        <p:spPr>
          <a:xfrm>
            <a:off x="8965593" y="2169257"/>
            <a:ext cx="636234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F80D9B2E-A8B0-CF24-E713-023CD8658FEB}"/>
              </a:ext>
            </a:extLst>
          </p:cNvPr>
          <p:cNvCxnSpPr>
            <a:cxnSpLocks/>
          </p:cNvCxnSpPr>
          <p:nvPr/>
        </p:nvCxnSpPr>
        <p:spPr>
          <a:xfrm>
            <a:off x="9650159" y="2169257"/>
            <a:ext cx="636234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5BE89455-77B8-17C7-092A-725FF967218D}"/>
              </a:ext>
            </a:extLst>
          </p:cNvPr>
          <p:cNvSpPr txBox="1"/>
          <p:nvPr/>
        </p:nvSpPr>
        <p:spPr>
          <a:xfrm>
            <a:off x="8926135" y="1845207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G401</a:t>
            </a:r>
            <a:endParaRPr kumimoji="1" lang="ja-US" altLang="en-US" dirty="0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1D9BB005-7FF1-A0A2-D67A-01F62643D828}"/>
              </a:ext>
            </a:extLst>
          </p:cNvPr>
          <p:cNvSpPr txBox="1"/>
          <p:nvPr/>
        </p:nvSpPr>
        <p:spPr>
          <a:xfrm>
            <a:off x="9659960" y="1845207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JMU</a:t>
            </a:r>
            <a:endParaRPr kumimoji="1" lang="ja-US" altLang="en-US" dirty="0"/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1B7C94F9-147C-7D36-CDD9-E8C557B88C89}"/>
              </a:ext>
            </a:extLst>
          </p:cNvPr>
          <p:cNvSpPr txBox="1"/>
          <p:nvPr/>
        </p:nvSpPr>
        <p:spPr>
          <a:xfrm>
            <a:off x="8962578" y="2187048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85BDFF4E-9B53-A885-F902-9E23A18506BD}"/>
              </a:ext>
            </a:extLst>
          </p:cNvPr>
          <p:cNvSpPr txBox="1"/>
          <p:nvPr/>
        </p:nvSpPr>
        <p:spPr>
          <a:xfrm>
            <a:off x="9292778" y="2187048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C2DA68F1-2D70-C58F-A596-BF0C969CC001}"/>
              </a:ext>
            </a:extLst>
          </p:cNvPr>
          <p:cNvSpPr txBox="1"/>
          <p:nvPr/>
        </p:nvSpPr>
        <p:spPr>
          <a:xfrm>
            <a:off x="9940478" y="2174348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9CD70026-2867-913C-671C-0360B6713A49}"/>
              </a:ext>
            </a:extLst>
          </p:cNvPr>
          <p:cNvSpPr txBox="1"/>
          <p:nvPr/>
        </p:nvSpPr>
        <p:spPr>
          <a:xfrm>
            <a:off x="9622978" y="2174348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sp>
        <p:nvSpPr>
          <p:cNvPr id="71" name="右矢印 70">
            <a:extLst>
              <a:ext uri="{FF2B5EF4-FFF2-40B4-BE49-F238E27FC236}">
                <a16:creationId xmlns:a16="http://schemas.microsoft.com/office/drawing/2014/main" id="{822C467C-393A-B87A-69C7-319065DB89C4}"/>
              </a:ext>
            </a:extLst>
          </p:cNvPr>
          <p:cNvSpPr/>
          <p:nvPr/>
        </p:nvSpPr>
        <p:spPr>
          <a:xfrm rot="10800000">
            <a:off x="3648261" y="2885763"/>
            <a:ext cx="234598" cy="4571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  <p:sp>
        <p:nvSpPr>
          <p:cNvPr id="72" name="右矢印 71">
            <a:extLst>
              <a:ext uri="{FF2B5EF4-FFF2-40B4-BE49-F238E27FC236}">
                <a16:creationId xmlns:a16="http://schemas.microsoft.com/office/drawing/2014/main" id="{3B677D7C-CB47-ECBD-DEED-B807DC87E9A3}"/>
              </a:ext>
            </a:extLst>
          </p:cNvPr>
          <p:cNvSpPr/>
          <p:nvPr/>
        </p:nvSpPr>
        <p:spPr>
          <a:xfrm rot="10800000" flipV="1">
            <a:off x="3648261" y="2992446"/>
            <a:ext cx="234598" cy="4571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  <p:sp>
        <p:nvSpPr>
          <p:cNvPr id="73" name="右矢印 72">
            <a:extLst>
              <a:ext uri="{FF2B5EF4-FFF2-40B4-BE49-F238E27FC236}">
                <a16:creationId xmlns:a16="http://schemas.microsoft.com/office/drawing/2014/main" id="{B4FCF1D6-003E-C818-E8CF-AC766D1F6C2A}"/>
              </a:ext>
            </a:extLst>
          </p:cNvPr>
          <p:cNvSpPr/>
          <p:nvPr/>
        </p:nvSpPr>
        <p:spPr>
          <a:xfrm rot="10800000">
            <a:off x="7524969" y="3560991"/>
            <a:ext cx="234598" cy="4571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  <p:sp>
        <p:nvSpPr>
          <p:cNvPr id="74" name="右矢印 73">
            <a:extLst>
              <a:ext uri="{FF2B5EF4-FFF2-40B4-BE49-F238E27FC236}">
                <a16:creationId xmlns:a16="http://schemas.microsoft.com/office/drawing/2014/main" id="{62ED967F-0E3F-A3E5-C3C9-14AFB4CBA7F7}"/>
              </a:ext>
            </a:extLst>
          </p:cNvPr>
          <p:cNvSpPr/>
          <p:nvPr/>
        </p:nvSpPr>
        <p:spPr>
          <a:xfrm rot="10800000">
            <a:off x="11659519" y="2747739"/>
            <a:ext cx="234598" cy="4571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8F33D27E-8BD7-815B-1B1F-0E944011940E}"/>
              </a:ext>
            </a:extLst>
          </p:cNvPr>
          <p:cNvSpPr txBox="1"/>
          <p:nvPr/>
        </p:nvSpPr>
        <p:spPr>
          <a:xfrm>
            <a:off x="1081596" y="2751053"/>
            <a:ext cx="279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ECF03864-04EA-A08C-D010-E26406BCA226}"/>
              </a:ext>
            </a:extLst>
          </p:cNvPr>
          <p:cNvSpPr txBox="1"/>
          <p:nvPr/>
        </p:nvSpPr>
        <p:spPr>
          <a:xfrm>
            <a:off x="1363120" y="2738307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.1</a:t>
            </a:r>
            <a:endParaRPr kumimoji="1" lang="ja-US" altLang="en-US" sz="1200" dirty="0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E927C295-26C8-12BB-A7FE-7F288A03485E}"/>
              </a:ext>
            </a:extLst>
          </p:cNvPr>
          <p:cNvSpPr txBox="1"/>
          <p:nvPr/>
        </p:nvSpPr>
        <p:spPr>
          <a:xfrm>
            <a:off x="1087360" y="3044456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B5286845-E8D3-528A-63A4-3FABA9241F5D}"/>
              </a:ext>
            </a:extLst>
          </p:cNvPr>
          <p:cNvSpPr txBox="1"/>
          <p:nvPr/>
        </p:nvSpPr>
        <p:spPr>
          <a:xfrm>
            <a:off x="1999903" y="2713813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9</a:t>
            </a:r>
            <a:endParaRPr kumimoji="1" lang="ja-US" altLang="en-US" sz="1200" dirty="0"/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4F97C9AE-9072-54D5-3AB7-C2F4ED717283}"/>
              </a:ext>
            </a:extLst>
          </p:cNvPr>
          <p:cNvSpPr txBox="1"/>
          <p:nvPr/>
        </p:nvSpPr>
        <p:spPr>
          <a:xfrm>
            <a:off x="1353880" y="3044456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2.6</a:t>
            </a:r>
            <a:endParaRPr kumimoji="1" lang="ja-US" altLang="en-US" sz="1200" dirty="0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76D7BF70-556F-70CD-460B-0C45DF7807F8}"/>
              </a:ext>
            </a:extLst>
          </p:cNvPr>
          <p:cNvSpPr txBox="1"/>
          <p:nvPr/>
        </p:nvSpPr>
        <p:spPr>
          <a:xfrm>
            <a:off x="1673149" y="3044456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.1</a:t>
            </a:r>
            <a:endParaRPr kumimoji="1" lang="ja-US" altLang="en-US" sz="1200" dirty="0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36669A72-B9E1-0DEE-50B7-A1D10A013E00}"/>
              </a:ext>
            </a:extLst>
          </p:cNvPr>
          <p:cNvSpPr txBox="1"/>
          <p:nvPr/>
        </p:nvSpPr>
        <p:spPr>
          <a:xfrm>
            <a:off x="1990300" y="3044456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2.5</a:t>
            </a:r>
            <a:endParaRPr kumimoji="1" lang="ja-US" altLang="en-US" sz="1200" dirty="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153E644B-F37C-9CF5-5E2A-91FCB0526B9A}"/>
              </a:ext>
            </a:extLst>
          </p:cNvPr>
          <p:cNvSpPr txBox="1"/>
          <p:nvPr/>
        </p:nvSpPr>
        <p:spPr>
          <a:xfrm>
            <a:off x="4941772" y="3067952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20F2B725-BBBE-C9BE-2766-3B1C5C127D33}"/>
              </a:ext>
            </a:extLst>
          </p:cNvPr>
          <p:cNvSpPr txBox="1"/>
          <p:nvPr/>
        </p:nvSpPr>
        <p:spPr>
          <a:xfrm>
            <a:off x="5224598" y="3067952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6.0</a:t>
            </a:r>
            <a:endParaRPr kumimoji="1" lang="ja-US" altLang="en-US" sz="1200" dirty="0"/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48B16C80-1979-E99B-F65F-837ACCD016D2}"/>
              </a:ext>
            </a:extLst>
          </p:cNvPr>
          <p:cNvSpPr txBox="1"/>
          <p:nvPr/>
        </p:nvSpPr>
        <p:spPr>
          <a:xfrm>
            <a:off x="5536674" y="3067952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8</a:t>
            </a:r>
            <a:endParaRPr kumimoji="1" lang="ja-US" altLang="en-US" sz="1200" dirty="0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3FDA9C43-F4C8-E011-EBB6-010934D3F7D0}"/>
              </a:ext>
            </a:extLst>
          </p:cNvPr>
          <p:cNvSpPr txBox="1"/>
          <p:nvPr/>
        </p:nvSpPr>
        <p:spPr>
          <a:xfrm>
            <a:off x="5866476" y="3067952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9.6</a:t>
            </a:r>
            <a:endParaRPr kumimoji="1" lang="ja-US" altLang="en-US" sz="1200" dirty="0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E9C1FDB5-C1C0-AECD-FAAB-E49032740A7C}"/>
              </a:ext>
            </a:extLst>
          </p:cNvPr>
          <p:cNvSpPr txBox="1"/>
          <p:nvPr/>
        </p:nvSpPr>
        <p:spPr>
          <a:xfrm>
            <a:off x="9026437" y="2687884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BFFE57A3-DB22-29F4-1021-EF47718E32EE}"/>
              </a:ext>
            </a:extLst>
          </p:cNvPr>
          <p:cNvSpPr txBox="1"/>
          <p:nvPr/>
        </p:nvSpPr>
        <p:spPr>
          <a:xfrm>
            <a:off x="9301173" y="2688518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.2</a:t>
            </a:r>
            <a:endParaRPr kumimoji="1" lang="ja-US" altLang="en-US" sz="1200" dirty="0"/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8352D58E-5E62-86BC-DF52-AB7965221B0D}"/>
              </a:ext>
            </a:extLst>
          </p:cNvPr>
          <p:cNvSpPr txBox="1"/>
          <p:nvPr/>
        </p:nvSpPr>
        <p:spPr>
          <a:xfrm>
            <a:off x="9601827" y="2702198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.1</a:t>
            </a:r>
            <a:endParaRPr kumimoji="1" lang="ja-US" altLang="en-US" sz="1200" dirty="0"/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C4F44DE5-5496-8C93-778C-DBA20E0B57DC}"/>
              </a:ext>
            </a:extLst>
          </p:cNvPr>
          <p:cNvSpPr txBox="1"/>
          <p:nvPr/>
        </p:nvSpPr>
        <p:spPr>
          <a:xfrm>
            <a:off x="9940478" y="2715447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9</a:t>
            </a:r>
            <a:endParaRPr kumimoji="1" lang="ja-US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3053193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5D07DAC-18D3-F663-538E-F1ADB3A2EAC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図 90">
            <a:extLst>
              <a:ext uri="{FF2B5EF4-FFF2-40B4-BE49-F238E27FC236}">
                <a16:creationId xmlns:a16="http://schemas.microsoft.com/office/drawing/2014/main" id="{59260AFB-A264-939F-AAEA-F57CD10340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46607" y="1770816"/>
            <a:ext cx="3969709" cy="2780846"/>
          </a:xfrm>
          <a:prstGeom prst="rect">
            <a:avLst/>
          </a:prstGeom>
        </p:spPr>
      </p:pic>
      <p:pic>
        <p:nvPicPr>
          <p:cNvPr id="39" name="図 38" descr="白いバックグラウンドのスクリーンショット&#10;&#10;AI 生成コンテンツは誤りを含む可能性があります。">
            <a:extLst>
              <a:ext uri="{FF2B5EF4-FFF2-40B4-BE49-F238E27FC236}">
                <a16:creationId xmlns:a16="http://schemas.microsoft.com/office/drawing/2014/main" id="{7D80A991-FA6E-CC4C-DC79-BE06748E37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00584" y="1778856"/>
            <a:ext cx="3948573" cy="2766040"/>
          </a:xfrm>
          <a:prstGeom prst="rect">
            <a:avLst/>
          </a:prstGeom>
        </p:spPr>
      </p:pic>
      <p:pic>
        <p:nvPicPr>
          <p:cNvPr id="26" name="図 25" descr="屋内, 写真, 座る, 小さい が含まれている画像&#10;&#10;AI 生成コンテンツは誤りを含む可能性があります。">
            <a:extLst>
              <a:ext uri="{FF2B5EF4-FFF2-40B4-BE49-F238E27FC236}">
                <a16:creationId xmlns:a16="http://schemas.microsoft.com/office/drawing/2014/main" id="{4883FAA9-2ECB-9B11-CE3B-49EE146022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014" y="1764052"/>
            <a:ext cx="3969710" cy="2780846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312CC40-1857-0D36-6C2F-6262F2A707E6}"/>
              </a:ext>
            </a:extLst>
          </p:cNvPr>
          <p:cNvSpPr txBox="1"/>
          <p:nvPr/>
        </p:nvSpPr>
        <p:spPr>
          <a:xfrm>
            <a:off x="42162" y="1291895"/>
            <a:ext cx="1639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u="sng" dirty="0"/>
              <a:t>Figure 2C</a:t>
            </a:r>
            <a:endParaRPr kumimoji="1" lang="ja-US" altLang="en-US" b="1" u="sng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A1D93917-EF49-7270-E026-536FB866E8E0}"/>
              </a:ext>
            </a:extLst>
          </p:cNvPr>
          <p:cNvSpPr txBox="1"/>
          <p:nvPr/>
        </p:nvSpPr>
        <p:spPr>
          <a:xfrm>
            <a:off x="1053605" y="3945673"/>
            <a:ext cx="32350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Cyclin B1 (60 </a:t>
            </a:r>
            <a:r>
              <a:rPr kumimoji="1" lang="en-US" altLang="ja-US" b="1" dirty="0" err="1"/>
              <a:t>kDa</a:t>
            </a:r>
            <a:r>
              <a:rPr kumimoji="1" lang="en-US" altLang="ja-US" b="1" dirty="0"/>
              <a:t>)</a:t>
            </a: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B5E87CAB-31AF-3519-D97A-1096E59FBD8E}"/>
              </a:ext>
            </a:extLst>
          </p:cNvPr>
          <p:cNvSpPr txBox="1"/>
          <p:nvPr/>
        </p:nvSpPr>
        <p:spPr>
          <a:xfrm>
            <a:off x="4980643" y="3942578"/>
            <a:ext cx="40377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p21(21 </a:t>
            </a:r>
            <a:r>
              <a:rPr kumimoji="1" lang="en-US" altLang="ja-US" b="1" dirty="0" err="1"/>
              <a:t>kDa</a:t>
            </a:r>
            <a:r>
              <a:rPr kumimoji="1" lang="en-US" altLang="ja-US" b="1" dirty="0"/>
              <a:t>)</a:t>
            </a:r>
            <a:endParaRPr kumimoji="1" lang="ja-US" altLang="en-US" b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4EFBB41-23B5-5A43-9484-37634A323316}"/>
              </a:ext>
            </a:extLst>
          </p:cNvPr>
          <p:cNvSpPr txBox="1"/>
          <p:nvPr/>
        </p:nvSpPr>
        <p:spPr>
          <a:xfrm>
            <a:off x="9131875" y="3945673"/>
            <a:ext cx="32350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Actin (43 </a:t>
            </a:r>
            <a:r>
              <a:rPr kumimoji="1" lang="en-US" altLang="ja-US" b="1" dirty="0" err="1"/>
              <a:t>kDa</a:t>
            </a:r>
            <a:r>
              <a:rPr kumimoji="1" lang="en-US" altLang="ja-US" b="1" dirty="0"/>
              <a:t>)</a:t>
            </a:r>
            <a:endParaRPr kumimoji="1" lang="ja-US" altLang="en-US" b="1" dirty="0"/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28B47A21-05BE-41EE-CCDD-72B9F7C65D56}"/>
              </a:ext>
            </a:extLst>
          </p:cNvPr>
          <p:cNvCxnSpPr/>
          <p:nvPr/>
        </p:nvCxnSpPr>
        <p:spPr>
          <a:xfrm>
            <a:off x="399555" y="2722282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52068AA-2310-7325-1450-87B2582D94C6}"/>
              </a:ext>
            </a:extLst>
          </p:cNvPr>
          <p:cNvSpPr txBox="1"/>
          <p:nvPr/>
        </p:nvSpPr>
        <p:spPr>
          <a:xfrm>
            <a:off x="202769" y="2251935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 err="1"/>
              <a:t>kDa</a:t>
            </a:r>
            <a:endParaRPr kumimoji="1" lang="ja-US" altLang="en-US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0CC91225-F5F1-1F38-901D-29469A220098}"/>
              </a:ext>
            </a:extLst>
          </p:cNvPr>
          <p:cNvSpPr txBox="1"/>
          <p:nvPr/>
        </p:nvSpPr>
        <p:spPr>
          <a:xfrm>
            <a:off x="59836" y="2587996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/>
              <a:t>70</a:t>
            </a:r>
            <a:endParaRPr kumimoji="1" lang="ja-US" altLang="en-US" sz="1400" dirty="0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1BF3941C-92B0-2124-8614-81F1F1B05473}"/>
              </a:ext>
            </a:extLst>
          </p:cNvPr>
          <p:cNvCxnSpPr>
            <a:cxnSpLocks/>
          </p:cNvCxnSpPr>
          <p:nvPr/>
        </p:nvCxnSpPr>
        <p:spPr>
          <a:xfrm>
            <a:off x="770605" y="2169257"/>
            <a:ext cx="1352672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7344FD60-E792-F2F4-4DCE-09464600A597}"/>
              </a:ext>
            </a:extLst>
          </p:cNvPr>
          <p:cNvCxnSpPr>
            <a:cxnSpLocks/>
          </p:cNvCxnSpPr>
          <p:nvPr/>
        </p:nvCxnSpPr>
        <p:spPr>
          <a:xfrm>
            <a:off x="2123277" y="2657575"/>
            <a:ext cx="12196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1C85316-625B-884D-5840-D158C1BA29C1}"/>
              </a:ext>
            </a:extLst>
          </p:cNvPr>
          <p:cNvSpPr txBox="1"/>
          <p:nvPr/>
        </p:nvSpPr>
        <p:spPr>
          <a:xfrm>
            <a:off x="904851" y="1775267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Figure 2C </a:t>
            </a:r>
            <a:endParaRPr kumimoji="1" lang="ja-US" altLang="en-US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BC0A6F44-B421-46C4-360C-F93BF36F3413}"/>
              </a:ext>
            </a:extLst>
          </p:cNvPr>
          <p:cNvSpPr txBox="1"/>
          <p:nvPr/>
        </p:nvSpPr>
        <p:spPr>
          <a:xfrm>
            <a:off x="2230427" y="2240080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Unused</a:t>
            </a:r>
            <a:endParaRPr kumimoji="1" lang="ja-US" altLang="en-US" dirty="0"/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5835DE3D-B64E-B979-8ACA-63CF4076482E}"/>
              </a:ext>
            </a:extLst>
          </p:cNvPr>
          <p:cNvCxnSpPr>
            <a:cxnSpLocks/>
          </p:cNvCxnSpPr>
          <p:nvPr/>
        </p:nvCxnSpPr>
        <p:spPr>
          <a:xfrm>
            <a:off x="788261" y="2463346"/>
            <a:ext cx="636234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8B064605-FF98-E635-F51B-58D2A8279002}"/>
              </a:ext>
            </a:extLst>
          </p:cNvPr>
          <p:cNvCxnSpPr>
            <a:cxnSpLocks/>
          </p:cNvCxnSpPr>
          <p:nvPr/>
        </p:nvCxnSpPr>
        <p:spPr>
          <a:xfrm>
            <a:off x="1488312" y="2463346"/>
            <a:ext cx="636234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6307F753-C3D5-BEC4-2717-5C30FE749914}"/>
              </a:ext>
            </a:extLst>
          </p:cNvPr>
          <p:cNvSpPr txBox="1"/>
          <p:nvPr/>
        </p:nvSpPr>
        <p:spPr>
          <a:xfrm>
            <a:off x="778551" y="2127083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G401</a:t>
            </a:r>
            <a:endParaRPr kumimoji="1" lang="ja-US" altLang="en-US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3E82457-92C1-11E0-C744-FE2089C7E739}"/>
              </a:ext>
            </a:extLst>
          </p:cNvPr>
          <p:cNvSpPr txBox="1"/>
          <p:nvPr/>
        </p:nvSpPr>
        <p:spPr>
          <a:xfrm>
            <a:off x="1522915" y="2133710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JMU</a:t>
            </a:r>
            <a:endParaRPr kumimoji="1" lang="ja-US" altLang="en-US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56535431-9666-31EB-3C33-F75024A8D6F3}"/>
              </a:ext>
            </a:extLst>
          </p:cNvPr>
          <p:cNvSpPr txBox="1"/>
          <p:nvPr/>
        </p:nvSpPr>
        <p:spPr>
          <a:xfrm>
            <a:off x="10166205" y="4772130"/>
            <a:ext cx="2442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JMU: JMU-RTK-2</a:t>
            </a:r>
            <a:endParaRPr kumimoji="1" lang="ja-US" altLang="en-US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35FF35DC-AEEB-CCDB-2038-0111534447E7}"/>
              </a:ext>
            </a:extLst>
          </p:cNvPr>
          <p:cNvSpPr txBox="1"/>
          <p:nvPr/>
        </p:nvSpPr>
        <p:spPr>
          <a:xfrm>
            <a:off x="10166206" y="5084281"/>
            <a:ext cx="2442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: Control</a:t>
            </a:r>
            <a:endParaRPr kumimoji="1" lang="ja-US" altLang="en-US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D2C3F0B-7DC5-F527-1732-0849F9C26AC1}"/>
              </a:ext>
            </a:extLst>
          </p:cNvPr>
          <p:cNvSpPr txBox="1"/>
          <p:nvPr/>
        </p:nvSpPr>
        <p:spPr>
          <a:xfrm>
            <a:off x="10166205" y="5396432"/>
            <a:ext cx="2442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: OTS964</a:t>
            </a:r>
            <a:endParaRPr kumimoji="1" lang="ja-US" altLang="en-US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891409C-2B4A-7BD0-2321-3D222D79DFAF}"/>
              </a:ext>
            </a:extLst>
          </p:cNvPr>
          <p:cNvSpPr txBox="1"/>
          <p:nvPr/>
        </p:nvSpPr>
        <p:spPr>
          <a:xfrm>
            <a:off x="809126" y="2439046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3B69400-EEB5-99A1-A21A-CE4BF30916EA}"/>
              </a:ext>
            </a:extLst>
          </p:cNvPr>
          <p:cNvSpPr txBox="1"/>
          <p:nvPr/>
        </p:nvSpPr>
        <p:spPr>
          <a:xfrm>
            <a:off x="1119925" y="2425672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CE313086-A6FC-8EB3-0111-BB70FE3DAEA5}"/>
              </a:ext>
            </a:extLst>
          </p:cNvPr>
          <p:cNvSpPr txBox="1"/>
          <p:nvPr/>
        </p:nvSpPr>
        <p:spPr>
          <a:xfrm>
            <a:off x="1784682" y="2425672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3F40FE8-359E-5BE2-C5F2-6D3D57AF1AAA}"/>
              </a:ext>
            </a:extLst>
          </p:cNvPr>
          <p:cNvSpPr txBox="1"/>
          <p:nvPr/>
        </p:nvSpPr>
        <p:spPr>
          <a:xfrm>
            <a:off x="1460149" y="2437292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37D0676B-F7DC-DF1C-0DB2-3AD3284DE888}"/>
              </a:ext>
            </a:extLst>
          </p:cNvPr>
          <p:cNvCxnSpPr/>
          <p:nvPr/>
        </p:nvCxnSpPr>
        <p:spPr>
          <a:xfrm>
            <a:off x="4326160" y="2437292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292CE90A-B34B-3D72-6684-320509AAE236}"/>
              </a:ext>
            </a:extLst>
          </p:cNvPr>
          <p:cNvCxnSpPr/>
          <p:nvPr/>
        </p:nvCxnSpPr>
        <p:spPr>
          <a:xfrm>
            <a:off x="8386392" y="2853946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2E1E176C-E8C7-1CFE-B211-007A9B4FF9FA}"/>
              </a:ext>
            </a:extLst>
          </p:cNvPr>
          <p:cNvCxnSpPr/>
          <p:nvPr/>
        </p:nvCxnSpPr>
        <p:spPr>
          <a:xfrm>
            <a:off x="4326160" y="2240080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03BB3E7C-38AD-134C-B2B7-18D4487F0532}"/>
              </a:ext>
            </a:extLst>
          </p:cNvPr>
          <p:cNvCxnSpPr>
            <a:cxnSpLocks/>
          </p:cNvCxnSpPr>
          <p:nvPr/>
        </p:nvCxnSpPr>
        <p:spPr>
          <a:xfrm>
            <a:off x="4841741" y="1584954"/>
            <a:ext cx="12196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E84B26B4-E590-D348-033A-C3F3E6AF34AC}"/>
              </a:ext>
            </a:extLst>
          </p:cNvPr>
          <p:cNvCxnSpPr>
            <a:cxnSpLocks/>
          </p:cNvCxnSpPr>
          <p:nvPr/>
        </p:nvCxnSpPr>
        <p:spPr>
          <a:xfrm>
            <a:off x="6096000" y="2144599"/>
            <a:ext cx="12196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FE4A1EAA-87FF-57A6-9999-033FC64838BC}"/>
              </a:ext>
            </a:extLst>
          </p:cNvPr>
          <p:cNvSpPr txBox="1"/>
          <p:nvPr/>
        </p:nvSpPr>
        <p:spPr>
          <a:xfrm>
            <a:off x="4912461" y="1268524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Figure 2C </a:t>
            </a:r>
            <a:endParaRPr kumimoji="1" lang="ja-US" altLang="en-US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72A5BAAD-A2A4-84F6-161F-29B38DD241BB}"/>
              </a:ext>
            </a:extLst>
          </p:cNvPr>
          <p:cNvSpPr txBox="1"/>
          <p:nvPr/>
        </p:nvSpPr>
        <p:spPr>
          <a:xfrm>
            <a:off x="6241781" y="1788731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Unused</a:t>
            </a:r>
            <a:endParaRPr kumimoji="1" lang="ja-US" altLang="en-US" dirty="0"/>
          </a:p>
        </p:txBody>
      </p: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146AECA4-E4D2-3A2D-F15E-AC9FE8539F80}"/>
              </a:ext>
            </a:extLst>
          </p:cNvPr>
          <p:cNvCxnSpPr>
            <a:cxnSpLocks/>
          </p:cNvCxnSpPr>
          <p:nvPr/>
        </p:nvCxnSpPr>
        <p:spPr>
          <a:xfrm>
            <a:off x="4837562" y="1890188"/>
            <a:ext cx="636234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C1A865D9-2D9F-F1CC-2A1C-F3B7584DDD5A}"/>
              </a:ext>
            </a:extLst>
          </p:cNvPr>
          <p:cNvCxnSpPr>
            <a:cxnSpLocks/>
          </p:cNvCxnSpPr>
          <p:nvPr/>
        </p:nvCxnSpPr>
        <p:spPr>
          <a:xfrm>
            <a:off x="5536674" y="1890186"/>
            <a:ext cx="542709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DB3A2F13-87FF-2BB2-C996-10DFF31AE499}"/>
              </a:ext>
            </a:extLst>
          </p:cNvPr>
          <p:cNvSpPr txBox="1"/>
          <p:nvPr/>
        </p:nvSpPr>
        <p:spPr>
          <a:xfrm>
            <a:off x="4810609" y="1550998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G401</a:t>
            </a:r>
            <a:endParaRPr kumimoji="1" lang="ja-US" altLang="en-US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E45CB24C-4A11-808C-7BEE-6EBC23CDABD7}"/>
              </a:ext>
            </a:extLst>
          </p:cNvPr>
          <p:cNvSpPr txBox="1"/>
          <p:nvPr/>
        </p:nvSpPr>
        <p:spPr>
          <a:xfrm>
            <a:off x="5516882" y="1529927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JMU</a:t>
            </a:r>
            <a:endParaRPr kumimoji="1" lang="ja-US" altLang="en-US" dirty="0"/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67E3F33E-3FB0-6480-2240-95B72AC2AE07}"/>
              </a:ext>
            </a:extLst>
          </p:cNvPr>
          <p:cNvSpPr txBox="1"/>
          <p:nvPr/>
        </p:nvSpPr>
        <p:spPr>
          <a:xfrm>
            <a:off x="4772422" y="1890186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9ECB28F8-7B0F-75BF-80A9-9F6DB3A5505D}"/>
              </a:ext>
            </a:extLst>
          </p:cNvPr>
          <p:cNvSpPr txBox="1"/>
          <p:nvPr/>
        </p:nvSpPr>
        <p:spPr>
          <a:xfrm>
            <a:off x="5120154" y="1890186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7A04579E-5C25-3D29-F140-5E1963E74D55}"/>
              </a:ext>
            </a:extLst>
          </p:cNvPr>
          <p:cNvSpPr txBox="1"/>
          <p:nvPr/>
        </p:nvSpPr>
        <p:spPr>
          <a:xfrm>
            <a:off x="5740788" y="1878188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F34A6B1D-93B4-5E86-3EB3-DFE670ED09BE}"/>
              </a:ext>
            </a:extLst>
          </p:cNvPr>
          <p:cNvSpPr txBox="1"/>
          <p:nvPr/>
        </p:nvSpPr>
        <p:spPr>
          <a:xfrm>
            <a:off x="5424561" y="1878188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F20AEF85-DE24-C86F-7E91-0CB7857EA4B9}"/>
              </a:ext>
            </a:extLst>
          </p:cNvPr>
          <p:cNvSpPr txBox="1"/>
          <p:nvPr/>
        </p:nvSpPr>
        <p:spPr>
          <a:xfrm>
            <a:off x="7969096" y="2401043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 err="1"/>
              <a:t>kDa</a:t>
            </a:r>
            <a:endParaRPr kumimoji="1" lang="ja-US" altLang="en-US" sz="1400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DA9EC21D-A297-1E7B-A697-8B43DDCAD485}"/>
              </a:ext>
            </a:extLst>
          </p:cNvPr>
          <p:cNvSpPr txBox="1"/>
          <p:nvPr/>
        </p:nvSpPr>
        <p:spPr>
          <a:xfrm>
            <a:off x="8025376" y="2709088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/>
              <a:t>40</a:t>
            </a:r>
            <a:endParaRPr kumimoji="1" lang="ja-US" altLang="en-US" sz="1400" dirty="0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BFC7B63-D292-9940-D97A-E83018D0B07B}"/>
              </a:ext>
            </a:extLst>
          </p:cNvPr>
          <p:cNvSpPr txBox="1"/>
          <p:nvPr/>
        </p:nvSpPr>
        <p:spPr>
          <a:xfrm>
            <a:off x="4013755" y="1855115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 err="1"/>
              <a:t>kDa</a:t>
            </a:r>
            <a:endParaRPr kumimoji="1" lang="ja-US" altLang="en-US" sz="1400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BBA6FC30-3373-B63D-5CF3-1125C44C8613}"/>
              </a:ext>
            </a:extLst>
          </p:cNvPr>
          <p:cNvSpPr txBox="1"/>
          <p:nvPr/>
        </p:nvSpPr>
        <p:spPr>
          <a:xfrm>
            <a:off x="4012620" y="2296218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/>
              <a:t>25</a:t>
            </a:r>
            <a:endParaRPr kumimoji="1" lang="ja-US" altLang="en-US" sz="1400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181672FE-76A1-B146-963D-F3009B958D09}"/>
              </a:ext>
            </a:extLst>
          </p:cNvPr>
          <p:cNvSpPr txBox="1"/>
          <p:nvPr/>
        </p:nvSpPr>
        <p:spPr>
          <a:xfrm>
            <a:off x="4006025" y="2080214"/>
            <a:ext cx="5363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400" dirty="0"/>
              <a:t>35</a:t>
            </a:r>
            <a:endParaRPr kumimoji="1" lang="ja-US" altLang="en-US" sz="1400" dirty="0"/>
          </a:p>
        </p:txBody>
      </p: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B18CA124-C3DF-852C-2479-6C3EA05D83CB}"/>
              </a:ext>
            </a:extLst>
          </p:cNvPr>
          <p:cNvCxnSpPr>
            <a:cxnSpLocks/>
          </p:cNvCxnSpPr>
          <p:nvPr/>
        </p:nvCxnSpPr>
        <p:spPr>
          <a:xfrm>
            <a:off x="8887008" y="2009003"/>
            <a:ext cx="12196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FBA330E7-9C16-B263-5897-CBACA3AEC563}"/>
              </a:ext>
            </a:extLst>
          </p:cNvPr>
          <p:cNvCxnSpPr>
            <a:cxnSpLocks/>
          </p:cNvCxnSpPr>
          <p:nvPr/>
        </p:nvCxnSpPr>
        <p:spPr>
          <a:xfrm>
            <a:off x="10162049" y="2590348"/>
            <a:ext cx="12196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2183BE96-E962-3EAD-C062-00DFA14FEE09}"/>
              </a:ext>
            </a:extLst>
          </p:cNvPr>
          <p:cNvSpPr txBox="1"/>
          <p:nvPr/>
        </p:nvSpPr>
        <p:spPr>
          <a:xfrm>
            <a:off x="8926135" y="1604985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Figure 2C </a:t>
            </a:r>
            <a:endParaRPr kumimoji="1" lang="ja-US" altLang="en-US" dirty="0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F6B46CB2-0D19-B3EA-A5C8-984214D0F775}"/>
              </a:ext>
            </a:extLst>
          </p:cNvPr>
          <p:cNvSpPr txBox="1"/>
          <p:nvPr/>
        </p:nvSpPr>
        <p:spPr>
          <a:xfrm>
            <a:off x="10245917" y="2177120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Unused</a:t>
            </a:r>
            <a:endParaRPr kumimoji="1" lang="ja-US" altLang="en-US" dirty="0"/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D2A3387E-4754-1B5A-F19A-DBEF37CBD853}"/>
              </a:ext>
            </a:extLst>
          </p:cNvPr>
          <p:cNvCxnSpPr>
            <a:cxnSpLocks/>
          </p:cNvCxnSpPr>
          <p:nvPr/>
        </p:nvCxnSpPr>
        <p:spPr>
          <a:xfrm>
            <a:off x="8860622" y="2337947"/>
            <a:ext cx="636234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40E05876-E9C1-4792-784D-C35643CADBD8}"/>
              </a:ext>
            </a:extLst>
          </p:cNvPr>
          <p:cNvCxnSpPr>
            <a:cxnSpLocks/>
          </p:cNvCxnSpPr>
          <p:nvPr/>
        </p:nvCxnSpPr>
        <p:spPr>
          <a:xfrm>
            <a:off x="9525815" y="2338441"/>
            <a:ext cx="636234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98E61164-B4F2-8BCC-CD0D-36903FC6A63C}"/>
              </a:ext>
            </a:extLst>
          </p:cNvPr>
          <p:cNvSpPr txBox="1"/>
          <p:nvPr/>
        </p:nvSpPr>
        <p:spPr>
          <a:xfrm>
            <a:off x="8825250" y="1986677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G401</a:t>
            </a:r>
            <a:endParaRPr kumimoji="1" lang="ja-US" altLang="en-US" dirty="0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4FD3BCF4-EAEA-3E1D-BBDA-5EA85489A3F7}"/>
              </a:ext>
            </a:extLst>
          </p:cNvPr>
          <p:cNvSpPr txBox="1"/>
          <p:nvPr/>
        </p:nvSpPr>
        <p:spPr>
          <a:xfrm>
            <a:off x="9562242" y="1963784"/>
            <a:ext cx="11669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JMU</a:t>
            </a:r>
            <a:endParaRPr kumimoji="1" lang="ja-US" altLang="en-US" dirty="0"/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4E32D58D-E299-D745-6620-18770304EC56}"/>
              </a:ext>
            </a:extLst>
          </p:cNvPr>
          <p:cNvSpPr txBox="1"/>
          <p:nvPr/>
        </p:nvSpPr>
        <p:spPr>
          <a:xfrm>
            <a:off x="8825940" y="2337947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40BF18AF-A29C-9442-C64D-D30C049D02A6}"/>
              </a:ext>
            </a:extLst>
          </p:cNvPr>
          <p:cNvSpPr txBox="1"/>
          <p:nvPr/>
        </p:nvSpPr>
        <p:spPr>
          <a:xfrm>
            <a:off x="9139779" y="2329043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D32CA0E1-69E8-D5A8-FA1F-55DA827426F0}"/>
              </a:ext>
            </a:extLst>
          </p:cNvPr>
          <p:cNvSpPr txBox="1"/>
          <p:nvPr/>
        </p:nvSpPr>
        <p:spPr>
          <a:xfrm>
            <a:off x="9770982" y="2318376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</a:t>
            </a:r>
            <a:endParaRPr kumimoji="1" lang="ja-US" altLang="en-US" dirty="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CF33F491-05BB-1AB7-2869-4F3E2AA532C8}"/>
              </a:ext>
            </a:extLst>
          </p:cNvPr>
          <p:cNvSpPr txBox="1"/>
          <p:nvPr/>
        </p:nvSpPr>
        <p:spPr>
          <a:xfrm>
            <a:off x="9480861" y="2327790"/>
            <a:ext cx="33859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</a:t>
            </a:r>
            <a:endParaRPr kumimoji="1" lang="ja-US" altLang="en-US" dirty="0"/>
          </a:p>
        </p:txBody>
      </p:sp>
      <p:sp>
        <p:nvSpPr>
          <p:cNvPr id="72" name="右矢印 71">
            <a:extLst>
              <a:ext uri="{FF2B5EF4-FFF2-40B4-BE49-F238E27FC236}">
                <a16:creationId xmlns:a16="http://schemas.microsoft.com/office/drawing/2014/main" id="{07CCF8A9-3F83-0B7F-9C01-872699B45070}"/>
              </a:ext>
            </a:extLst>
          </p:cNvPr>
          <p:cNvSpPr/>
          <p:nvPr/>
        </p:nvSpPr>
        <p:spPr>
          <a:xfrm flipV="1">
            <a:off x="517437" y="2794770"/>
            <a:ext cx="244570" cy="71414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  <p:sp>
        <p:nvSpPr>
          <p:cNvPr id="73" name="右矢印 72">
            <a:extLst>
              <a:ext uri="{FF2B5EF4-FFF2-40B4-BE49-F238E27FC236}">
                <a16:creationId xmlns:a16="http://schemas.microsoft.com/office/drawing/2014/main" id="{F7B91853-8E2A-7D63-9E83-9DE2FD600E6F}"/>
              </a:ext>
            </a:extLst>
          </p:cNvPr>
          <p:cNvSpPr/>
          <p:nvPr/>
        </p:nvSpPr>
        <p:spPr>
          <a:xfrm>
            <a:off x="4521450" y="2512456"/>
            <a:ext cx="234598" cy="4571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  <p:sp>
        <p:nvSpPr>
          <p:cNvPr id="74" name="右矢印 73">
            <a:extLst>
              <a:ext uri="{FF2B5EF4-FFF2-40B4-BE49-F238E27FC236}">
                <a16:creationId xmlns:a16="http://schemas.microsoft.com/office/drawing/2014/main" id="{7D698BC9-359D-B241-3B42-393C52DB2BCC}"/>
              </a:ext>
            </a:extLst>
          </p:cNvPr>
          <p:cNvSpPr/>
          <p:nvPr/>
        </p:nvSpPr>
        <p:spPr>
          <a:xfrm>
            <a:off x="8534929" y="2748133"/>
            <a:ext cx="234598" cy="4571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AE50151C-3055-7167-317F-36AAFB898FCC}"/>
              </a:ext>
            </a:extLst>
          </p:cNvPr>
          <p:cNvSpPr txBox="1"/>
          <p:nvPr/>
        </p:nvSpPr>
        <p:spPr>
          <a:xfrm>
            <a:off x="836557" y="2875196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21877B4C-67AB-DA8A-4B5E-8F5888FE2B63}"/>
              </a:ext>
            </a:extLst>
          </p:cNvPr>
          <p:cNvSpPr txBox="1"/>
          <p:nvPr/>
        </p:nvSpPr>
        <p:spPr>
          <a:xfrm>
            <a:off x="1102872" y="2882699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5</a:t>
            </a:r>
            <a:endParaRPr kumimoji="1" lang="ja-US" altLang="en-US" sz="1200" dirty="0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6A661823-706A-B0BA-60FD-B35AA845B9BA}"/>
              </a:ext>
            </a:extLst>
          </p:cNvPr>
          <p:cNvSpPr txBox="1"/>
          <p:nvPr/>
        </p:nvSpPr>
        <p:spPr>
          <a:xfrm>
            <a:off x="1431459" y="2882699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6</a:t>
            </a:r>
            <a:endParaRPr kumimoji="1" lang="ja-US" altLang="en-US" sz="1200" dirty="0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7EEA4FFE-A8C2-D693-6171-85123DDFB552}"/>
              </a:ext>
            </a:extLst>
          </p:cNvPr>
          <p:cNvSpPr txBox="1"/>
          <p:nvPr/>
        </p:nvSpPr>
        <p:spPr>
          <a:xfrm>
            <a:off x="1740564" y="2882699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5</a:t>
            </a:r>
            <a:endParaRPr kumimoji="1" lang="ja-US" altLang="en-US" sz="1200" dirty="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B474EDF9-BE87-8597-BF6F-B8CA7D7D6FD9}"/>
              </a:ext>
            </a:extLst>
          </p:cNvPr>
          <p:cNvSpPr txBox="1"/>
          <p:nvPr/>
        </p:nvSpPr>
        <p:spPr>
          <a:xfrm>
            <a:off x="4817448" y="2576947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423EA8C5-B696-751E-F5FB-51CF8E899FB7}"/>
              </a:ext>
            </a:extLst>
          </p:cNvPr>
          <p:cNvSpPr txBox="1"/>
          <p:nvPr/>
        </p:nvSpPr>
        <p:spPr>
          <a:xfrm>
            <a:off x="5088975" y="2590348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8.0</a:t>
            </a:r>
            <a:endParaRPr kumimoji="1" lang="ja-US" altLang="en-US" sz="1200" dirty="0"/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76292E16-5727-80C0-5670-9D1697B52BA9}"/>
              </a:ext>
            </a:extLst>
          </p:cNvPr>
          <p:cNvSpPr txBox="1"/>
          <p:nvPr/>
        </p:nvSpPr>
        <p:spPr>
          <a:xfrm>
            <a:off x="5473918" y="2583782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8165CAAC-1870-BC29-DC44-C0545B9A55E2}"/>
              </a:ext>
            </a:extLst>
          </p:cNvPr>
          <p:cNvSpPr txBox="1"/>
          <p:nvPr/>
        </p:nvSpPr>
        <p:spPr>
          <a:xfrm>
            <a:off x="5724067" y="2583782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2.7</a:t>
            </a:r>
            <a:endParaRPr kumimoji="1" lang="ja-US" altLang="en-US" sz="1200" dirty="0"/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A912AACC-7069-1704-972B-DD9F37CEBB7D}"/>
              </a:ext>
            </a:extLst>
          </p:cNvPr>
          <p:cNvSpPr txBox="1"/>
          <p:nvPr/>
        </p:nvSpPr>
        <p:spPr>
          <a:xfrm>
            <a:off x="8881223" y="2806340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D94E7973-25C1-B781-A2B0-9D0A6715B678}"/>
              </a:ext>
            </a:extLst>
          </p:cNvPr>
          <p:cNvSpPr txBox="1"/>
          <p:nvPr/>
        </p:nvSpPr>
        <p:spPr>
          <a:xfrm>
            <a:off x="9122614" y="2806340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9</a:t>
            </a:r>
            <a:endParaRPr kumimoji="1" lang="ja-US" altLang="en-US" sz="1200" dirty="0"/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9EEE2E6B-7157-0C6A-EC16-DF2D03FD19D0}"/>
              </a:ext>
            </a:extLst>
          </p:cNvPr>
          <p:cNvSpPr txBox="1"/>
          <p:nvPr/>
        </p:nvSpPr>
        <p:spPr>
          <a:xfrm>
            <a:off x="9509596" y="2807073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2776BBE8-DAFE-C3C5-3E9F-D4FE7295C9DD}"/>
              </a:ext>
            </a:extLst>
          </p:cNvPr>
          <p:cNvSpPr txBox="1"/>
          <p:nvPr/>
        </p:nvSpPr>
        <p:spPr>
          <a:xfrm>
            <a:off x="9761097" y="2804159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9</a:t>
            </a:r>
            <a:endParaRPr kumimoji="1" lang="ja-US" altLang="en-US" sz="12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DD92E23-7B09-924A-18D6-594877ADBBDB}"/>
              </a:ext>
            </a:extLst>
          </p:cNvPr>
          <p:cNvSpPr txBox="1"/>
          <p:nvPr/>
        </p:nvSpPr>
        <p:spPr>
          <a:xfrm>
            <a:off x="114007" y="6290341"/>
            <a:ext cx="939558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kumimoji="1" lang="en-US" altLang="ja-US" sz="1400" b="1" dirty="0">
                <a:latin typeface="Palatino Linotype" panose="02040502050505030304" pitchFamily="18" charset="0"/>
              </a:rPr>
              <a:t>Supplementary Figure S3. </a:t>
            </a:r>
            <a:r>
              <a:rPr lang="en-US" altLang="ja-US" sz="1400" b="1" dirty="0">
                <a:effectLst/>
                <a:latin typeface="Palatino Linotype" panose="02040502050505030304" pitchFamily="18" charset="0"/>
              </a:rPr>
              <a:t>Uncropped Western blots corresponding to Figure 2C.</a:t>
            </a:r>
          </a:p>
        </p:txBody>
      </p:sp>
    </p:spTree>
    <p:extLst>
      <p:ext uri="{BB962C8B-B14F-4D97-AF65-F5344CB8AC3E}">
        <p14:creationId xmlns:p14="http://schemas.microsoft.com/office/powerpoint/2010/main" val="7218846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3C5FA29-ECE0-3D65-03D3-314F48F8642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F4E607F1-9E3C-5F84-574A-430EC8AD6165}"/>
              </a:ext>
            </a:extLst>
          </p:cNvPr>
          <p:cNvSpPr txBox="1"/>
          <p:nvPr/>
        </p:nvSpPr>
        <p:spPr>
          <a:xfrm>
            <a:off x="77206" y="43249"/>
            <a:ext cx="24123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u="sng" dirty="0"/>
              <a:t>Figure 2D and E</a:t>
            </a:r>
            <a:endParaRPr kumimoji="1" lang="ja-US" altLang="en-US" b="1" u="sng" dirty="0"/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23FC153A-5F79-D2C9-DD72-821EB05384A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4272" y="3462212"/>
            <a:ext cx="4212273" cy="2951309"/>
          </a:xfrm>
          <a:prstGeom prst="rect">
            <a:avLst/>
          </a:prstGeom>
          <a:ln>
            <a:noFill/>
          </a:ln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ACA80ABB-C31E-C0C3-4703-B797029065F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2249" y="412581"/>
            <a:ext cx="4212271" cy="2951308"/>
          </a:xfrm>
          <a:prstGeom prst="rect">
            <a:avLst/>
          </a:prstGeom>
          <a:ln>
            <a:noFill/>
          </a:ln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D3AB5E3C-580F-A52E-8744-6008352B215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04369" y="3451302"/>
            <a:ext cx="4212272" cy="2951309"/>
          </a:xfrm>
          <a:prstGeom prst="rect">
            <a:avLst/>
          </a:prstGeom>
          <a:ln>
            <a:noFill/>
          </a:ln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2119F8B6-3D92-5050-A84E-8221057467C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7660" y="412581"/>
            <a:ext cx="4177712" cy="2927094"/>
          </a:xfrm>
          <a:prstGeom prst="rect">
            <a:avLst/>
          </a:prstGeom>
          <a:ln>
            <a:noFill/>
          </a:ln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F2E79DA-F9DC-480A-9266-166268837E8C}"/>
              </a:ext>
            </a:extLst>
          </p:cNvPr>
          <p:cNvSpPr txBox="1"/>
          <p:nvPr/>
        </p:nvSpPr>
        <p:spPr>
          <a:xfrm>
            <a:off x="2801293" y="1844337"/>
            <a:ext cx="1772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p53 (53 </a:t>
            </a:r>
            <a:r>
              <a:rPr kumimoji="1" lang="en-US" altLang="ja-US" b="1" dirty="0" err="1"/>
              <a:t>kDa</a:t>
            </a:r>
            <a:r>
              <a:rPr kumimoji="1" lang="en-US" altLang="ja-US" b="1" dirty="0"/>
              <a:t>)</a:t>
            </a:r>
            <a:endParaRPr kumimoji="1" lang="ja-US" altLang="en-US" b="1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52699E9-5829-AE5B-9EC4-63FCF753D39B}"/>
              </a:ext>
            </a:extLst>
          </p:cNvPr>
          <p:cNvSpPr txBox="1"/>
          <p:nvPr/>
        </p:nvSpPr>
        <p:spPr>
          <a:xfrm>
            <a:off x="3122418" y="5921652"/>
            <a:ext cx="32350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Actin (43 </a:t>
            </a:r>
            <a:r>
              <a:rPr kumimoji="1" lang="en-US" altLang="ja-US" b="1" dirty="0" err="1"/>
              <a:t>kDa</a:t>
            </a:r>
            <a:r>
              <a:rPr kumimoji="1" lang="en-US" altLang="ja-US" b="1" dirty="0"/>
              <a:t>)</a:t>
            </a:r>
            <a:endParaRPr kumimoji="1" lang="ja-US" altLang="en-US" b="1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562DE85-A4ED-C07D-7F48-6819AA173780}"/>
              </a:ext>
            </a:extLst>
          </p:cNvPr>
          <p:cNvSpPr txBox="1"/>
          <p:nvPr/>
        </p:nvSpPr>
        <p:spPr>
          <a:xfrm>
            <a:off x="6983630" y="2877465"/>
            <a:ext cx="2652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p-SF3B1 (155 </a:t>
            </a:r>
            <a:r>
              <a:rPr kumimoji="1" lang="en-US" altLang="ja-US" b="1" dirty="0" err="1"/>
              <a:t>kDa</a:t>
            </a:r>
            <a:r>
              <a:rPr kumimoji="1" lang="en-US" altLang="ja-US" b="1" dirty="0"/>
              <a:t>)</a:t>
            </a:r>
            <a:endParaRPr kumimoji="1" lang="ja-US" altLang="en-US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9838075-E97E-0E97-763B-01E390C5E410}"/>
              </a:ext>
            </a:extLst>
          </p:cNvPr>
          <p:cNvSpPr txBox="1"/>
          <p:nvPr/>
        </p:nvSpPr>
        <p:spPr>
          <a:xfrm>
            <a:off x="6820249" y="5914393"/>
            <a:ext cx="26525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w-SF3B1 (155 </a:t>
            </a:r>
            <a:r>
              <a:rPr kumimoji="1" lang="en-US" altLang="ja-US" b="1" dirty="0" err="1"/>
              <a:t>kDa</a:t>
            </a:r>
            <a:r>
              <a:rPr kumimoji="1" lang="en-US" altLang="ja-US" b="1" dirty="0"/>
              <a:t>)</a:t>
            </a:r>
            <a:endParaRPr kumimoji="1" lang="ja-US" altLang="en-US" b="1" dirty="0"/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1F9C377B-6B2B-1BD3-6D9B-D7B65612789A}"/>
              </a:ext>
            </a:extLst>
          </p:cNvPr>
          <p:cNvCxnSpPr/>
          <p:nvPr/>
        </p:nvCxnSpPr>
        <p:spPr>
          <a:xfrm>
            <a:off x="1746506" y="1053321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1A9F8B32-7BC5-8BD7-710C-8DB69805CABB}"/>
              </a:ext>
            </a:extLst>
          </p:cNvPr>
          <p:cNvCxnSpPr/>
          <p:nvPr/>
        </p:nvCxnSpPr>
        <p:spPr>
          <a:xfrm>
            <a:off x="1746506" y="1269221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13636F36-DC68-AD8C-50F3-60D2F04239DC}"/>
              </a:ext>
            </a:extLst>
          </p:cNvPr>
          <p:cNvCxnSpPr/>
          <p:nvPr/>
        </p:nvCxnSpPr>
        <p:spPr>
          <a:xfrm>
            <a:off x="1733806" y="1497821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AAC14E1-09A3-527D-6E86-836D600A0C21}"/>
              </a:ext>
            </a:extLst>
          </p:cNvPr>
          <p:cNvSpPr txBox="1"/>
          <p:nvPr/>
        </p:nvSpPr>
        <p:spPr>
          <a:xfrm>
            <a:off x="1450577" y="590251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 err="1"/>
              <a:t>kDa</a:t>
            </a:r>
            <a:endParaRPr kumimoji="1" lang="ja-US" altLang="en-US" sz="12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72D6656-F3A0-E747-412F-BBE0E36E9FC3}"/>
              </a:ext>
            </a:extLst>
          </p:cNvPr>
          <p:cNvSpPr txBox="1"/>
          <p:nvPr/>
        </p:nvSpPr>
        <p:spPr>
          <a:xfrm>
            <a:off x="1434434" y="1352556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40</a:t>
            </a:r>
            <a:endParaRPr kumimoji="1" lang="ja-US" altLang="en-US" sz="12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F7CD687-E7A9-2A62-B2A7-C53807920858}"/>
              </a:ext>
            </a:extLst>
          </p:cNvPr>
          <p:cNvSpPr txBox="1"/>
          <p:nvPr/>
        </p:nvSpPr>
        <p:spPr>
          <a:xfrm>
            <a:off x="1443790" y="914186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70</a:t>
            </a:r>
            <a:endParaRPr kumimoji="1" lang="ja-US" altLang="en-US" sz="12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96F5BCB-63B8-32CB-21FF-1B4784E18BCC}"/>
              </a:ext>
            </a:extLst>
          </p:cNvPr>
          <p:cNvSpPr txBox="1"/>
          <p:nvPr/>
        </p:nvSpPr>
        <p:spPr>
          <a:xfrm>
            <a:off x="1438008" y="1131721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50</a:t>
            </a:r>
            <a:endParaRPr kumimoji="1" lang="ja-US" altLang="en-US" sz="1200" dirty="0"/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45B079A0-0001-C9A0-202C-5DDD71128D73}"/>
              </a:ext>
            </a:extLst>
          </p:cNvPr>
          <p:cNvCxnSpPr>
            <a:cxnSpLocks/>
          </p:cNvCxnSpPr>
          <p:nvPr/>
        </p:nvCxnSpPr>
        <p:spPr>
          <a:xfrm>
            <a:off x="2177501" y="653266"/>
            <a:ext cx="8989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D089D509-DDBA-65FD-D674-50037F6ED437}"/>
              </a:ext>
            </a:extLst>
          </p:cNvPr>
          <p:cNvSpPr txBox="1"/>
          <p:nvPr/>
        </p:nvSpPr>
        <p:spPr>
          <a:xfrm>
            <a:off x="2228673" y="379728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Figure 2C </a:t>
            </a:r>
            <a:endParaRPr kumimoji="1" lang="ja-US" altLang="en-US" sz="12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F68EA66E-EDFE-83CE-3104-B1992C884E8E}"/>
              </a:ext>
            </a:extLst>
          </p:cNvPr>
          <p:cNvSpPr txBox="1"/>
          <p:nvPr/>
        </p:nvSpPr>
        <p:spPr>
          <a:xfrm>
            <a:off x="3600409" y="630893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Unused</a:t>
            </a:r>
            <a:endParaRPr kumimoji="1" lang="ja-US" altLang="en-US" sz="1200" dirty="0"/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82EFF044-4679-BEB2-42F4-DB8B070D2E0F}"/>
              </a:ext>
            </a:extLst>
          </p:cNvPr>
          <p:cNvCxnSpPr>
            <a:cxnSpLocks/>
          </p:cNvCxnSpPr>
          <p:nvPr/>
        </p:nvCxnSpPr>
        <p:spPr>
          <a:xfrm>
            <a:off x="2188980" y="914186"/>
            <a:ext cx="417616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5062B203-6FD9-1506-FA0F-E628F6CB66EB}"/>
              </a:ext>
            </a:extLst>
          </p:cNvPr>
          <p:cNvSpPr txBox="1"/>
          <p:nvPr/>
        </p:nvSpPr>
        <p:spPr>
          <a:xfrm>
            <a:off x="2141175" y="653266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G401</a:t>
            </a:r>
            <a:endParaRPr kumimoji="1" lang="ja-US" altLang="en-US" sz="12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8DF7506-C211-9781-E967-0D5C51E49212}"/>
              </a:ext>
            </a:extLst>
          </p:cNvPr>
          <p:cNvSpPr txBox="1"/>
          <p:nvPr/>
        </p:nvSpPr>
        <p:spPr>
          <a:xfrm>
            <a:off x="2631996" y="653267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JMU</a:t>
            </a:r>
            <a:endParaRPr kumimoji="1" lang="ja-US" altLang="en-US" sz="1200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688367E-A50B-8743-380B-E3AB51F1894D}"/>
              </a:ext>
            </a:extLst>
          </p:cNvPr>
          <p:cNvSpPr txBox="1"/>
          <p:nvPr/>
        </p:nvSpPr>
        <p:spPr>
          <a:xfrm>
            <a:off x="2122736" y="892103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C</a:t>
            </a:r>
            <a:endParaRPr kumimoji="1" lang="ja-US" altLang="en-US" sz="12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38E07E8-811E-1536-A01C-A029EA4FAA5F}"/>
              </a:ext>
            </a:extLst>
          </p:cNvPr>
          <p:cNvSpPr txBox="1"/>
          <p:nvPr/>
        </p:nvSpPr>
        <p:spPr>
          <a:xfrm>
            <a:off x="2375259" y="892103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O</a:t>
            </a:r>
            <a:endParaRPr kumimoji="1" lang="ja-US" altLang="en-US" sz="1200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7358BF51-1D21-91D1-C4B9-619F22885CF5}"/>
              </a:ext>
            </a:extLst>
          </p:cNvPr>
          <p:cNvSpPr txBox="1"/>
          <p:nvPr/>
        </p:nvSpPr>
        <p:spPr>
          <a:xfrm>
            <a:off x="2809796" y="895916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O</a:t>
            </a:r>
            <a:endParaRPr kumimoji="1" lang="ja-US" altLang="en-US" sz="1200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60B6F438-FBE1-372F-D482-90BE65399C94}"/>
              </a:ext>
            </a:extLst>
          </p:cNvPr>
          <p:cNvSpPr txBox="1"/>
          <p:nvPr/>
        </p:nvSpPr>
        <p:spPr>
          <a:xfrm>
            <a:off x="2631996" y="895916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C</a:t>
            </a:r>
            <a:endParaRPr kumimoji="1" lang="ja-US" altLang="en-US" sz="1200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8602BBF-7938-FAD2-B6DD-9CA20EF9AF6B}"/>
              </a:ext>
            </a:extLst>
          </p:cNvPr>
          <p:cNvSpPr txBox="1"/>
          <p:nvPr/>
        </p:nvSpPr>
        <p:spPr>
          <a:xfrm>
            <a:off x="10217005" y="5434301"/>
            <a:ext cx="2442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JMU: JMU-RTK-2</a:t>
            </a:r>
            <a:endParaRPr kumimoji="1" lang="ja-US" altLang="en-US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F597D93-4BB8-0449-5067-166DA2D55A2B}"/>
              </a:ext>
            </a:extLst>
          </p:cNvPr>
          <p:cNvSpPr txBox="1"/>
          <p:nvPr/>
        </p:nvSpPr>
        <p:spPr>
          <a:xfrm>
            <a:off x="10217006" y="5746452"/>
            <a:ext cx="2442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C: Control</a:t>
            </a:r>
            <a:endParaRPr kumimoji="1" lang="ja-US" altLang="en-US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342FC4B8-623B-4A1E-181B-CCFEEABD7F8C}"/>
              </a:ext>
            </a:extLst>
          </p:cNvPr>
          <p:cNvSpPr txBox="1"/>
          <p:nvPr/>
        </p:nvSpPr>
        <p:spPr>
          <a:xfrm>
            <a:off x="10217005" y="6058603"/>
            <a:ext cx="2442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O: OTS964</a:t>
            </a:r>
            <a:endParaRPr kumimoji="1" lang="ja-US" altLang="en-US" dirty="0"/>
          </a:p>
        </p:txBody>
      </p: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27F5AD35-0CF8-1EF2-E2AC-3256BCE63B47}"/>
              </a:ext>
            </a:extLst>
          </p:cNvPr>
          <p:cNvCxnSpPr>
            <a:cxnSpLocks/>
          </p:cNvCxnSpPr>
          <p:nvPr/>
        </p:nvCxnSpPr>
        <p:spPr>
          <a:xfrm>
            <a:off x="2658880" y="914186"/>
            <a:ext cx="417616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C7599D06-A0F9-D412-D21F-BB350D9C86F7}"/>
              </a:ext>
            </a:extLst>
          </p:cNvPr>
          <p:cNvCxnSpPr>
            <a:cxnSpLocks/>
          </p:cNvCxnSpPr>
          <p:nvPr/>
        </p:nvCxnSpPr>
        <p:spPr>
          <a:xfrm>
            <a:off x="3111190" y="923131"/>
            <a:ext cx="1765610" cy="11722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右矢印 55">
            <a:extLst>
              <a:ext uri="{FF2B5EF4-FFF2-40B4-BE49-F238E27FC236}">
                <a16:creationId xmlns:a16="http://schemas.microsoft.com/office/drawing/2014/main" id="{0F3C8457-0A67-E933-ACFB-879FB2EC95A7}"/>
              </a:ext>
            </a:extLst>
          </p:cNvPr>
          <p:cNvSpPr/>
          <p:nvPr/>
        </p:nvSpPr>
        <p:spPr>
          <a:xfrm rot="10800000">
            <a:off x="4903818" y="1269221"/>
            <a:ext cx="234598" cy="4571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  <p:cxnSp>
        <p:nvCxnSpPr>
          <p:cNvPr id="57" name="直線コネクタ 56">
            <a:extLst>
              <a:ext uri="{FF2B5EF4-FFF2-40B4-BE49-F238E27FC236}">
                <a16:creationId xmlns:a16="http://schemas.microsoft.com/office/drawing/2014/main" id="{B906F87A-699B-4675-0206-A26B99F72CA0}"/>
              </a:ext>
            </a:extLst>
          </p:cNvPr>
          <p:cNvCxnSpPr/>
          <p:nvPr/>
        </p:nvCxnSpPr>
        <p:spPr>
          <a:xfrm>
            <a:off x="1722855" y="3580305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8" name="直線コネクタ 57">
            <a:extLst>
              <a:ext uri="{FF2B5EF4-FFF2-40B4-BE49-F238E27FC236}">
                <a16:creationId xmlns:a16="http://schemas.microsoft.com/office/drawing/2014/main" id="{2AF5908A-4F04-EBC9-1E70-B5A7C1285ADB}"/>
              </a:ext>
            </a:extLst>
          </p:cNvPr>
          <p:cNvCxnSpPr/>
          <p:nvPr/>
        </p:nvCxnSpPr>
        <p:spPr>
          <a:xfrm>
            <a:off x="1722855" y="3796205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59" name="直線コネクタ 58">
            <a:extLst>
              <a:ext uri="{FF2B5EF4-FFF2-40B4-BE49-F238E27FC236}">
                <a16:creationId xmlns:a16="http://schemas.microsoft.com/office/drawing/2014/main" id="{9359DDC9-2C72-7115-5E80-0C35C622CD04}"/>
              </a:ext>
            </a:extLst>
          </p:cNvPr>
          <p:cNvCxnSpPr/>
          <p:nvPr/>
        </p:nvCxnSpPr>
        <p:spPr>
          <a:xfrm>
            <a:off x="1710155" y="4024805"/>
            <a:ext cx="152400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249688D2-72FC-DF93-9218-A7DA4C6F9F47}"/>
              </a:ext>
            </a:extLst>
          </p:cNvPr>
          <p:cNvSpPr txBox="1"/>
          <p:nvPr/>
        </p:nvSpPr>
        <p:spPr>
          <a:xfrm>
            <a:off x="1478344" y="4081911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 err="1"/>
              <a:t>kDa</a:t>
            </a:r>
            <a:endParaRPr kumimoji="1" lang="ja-US" altLang="en-US" sz="1200" dirty="0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AC197EB8-885D-9CFE-6F7E-8579ED5BBB38}"/>
              </a:ext>
            </a:extLst>
          </p:cNvPr>
          <p:cNvSpPr txBox="1"/>
          <p:nvPr/>
        </p:nvSpPr>
        <p:spPr>
          <a:xfrm>
            <a:off x="1411178" y="3882949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40</a:t>
            </a:r>
            <a:endParaRPr kumimoji="1" lang="ja-US" altLang="en-US" sz="1200" dirty="0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A86A4D02-E9D2-E0FC-D8A3-4CE7F4BBE8A8}"/>
              </a:ext>
            </a:extLst>
          </p:cNvPr>
          <p:cNvSpPr txBox="1"/>
          <p:nvPr/>
        </p:nvSpPr>
        <p:spPr>
          <a:xfrm>
            <a:off x="1420139" y="3441170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70</a:t>
            </a:r>
            <a:endParaRPr kumimoji="1" lang="ja-US" altLang="en-US" sz="1200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773B1A56-08FA-C31D-3F5F-A012AFEB83EA}"/>
              </a:ext>
            </a:extLst>
          </p:cNvPr>
          <p:cNvSpPr txBox="1"/>
          <p:nvPr/>
        </p:nvSpPr>
        <p:spPr>
          <a:xfrm>
            <a:off x="1414357" y="3658705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50</a:t>
            </a:r>
            <a:endParaRPr kumimoji="1" lang="ja-US" altLang="en-US" sz="1200" dirty="0"/>
          </a:p>
        </p:txBody>
      </p: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FC71CE25-47E2-8861-1283-013D9FD6536D}"/>
              </a:ext>
            </a:extLst>
          </p:cNvPr>
          <p:cNvCxnSpPr>
            <a:cxnSpLocks/>
          </p:cNvCxnSpPr>
          <p:nvPr/>
        </p:nvCxnSpPr>
        <p:spPr>
          <a:xfrm>
            <a:off x="2187594" y="4543901"/>
            <a:ext cx="8989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8E54BE3E-0D17-EC1B-2D11-C78B97AD95B8}"/>
              </a:ext>
            </a:extLst>
          </p:cNvPr>
          <p:cNvSpPr txBox="1"/>
          <p:nvPr/>
        </p:nvSpPr>
        <p:spPr>
          <a:xfrm>
            <a:off x="2217832" y="4578589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Figure 2C </a:t>
            </a:r>
            <a:endParaRPr kumimoji="1" lang="ja-US" altLang="en-US" sz="1200" dirty="0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087D9027-978D-6BDA-AEA6-7B9086A825D9}"/>
              </a:ext>
            </a:extLst>
          </p:cNvPr>
          <p:cNvSpPr txBox="1"/>
          <p:nvPr/>
        </p:nvSpPr>
        <p:spPr>
          <a:xfrm>
            <a:off x="3284914" y="4098707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Unused</a:t>
            </a:r>
            <a:endParaRPr kumimoji="1" lang="ja-US" altLang="en-US" sz="1200" dirty="0"/>
          </a:p>
        </p:txBody>
      </p: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D5CE0B74-26A4-AA8F-1F99-E078839EB386}"/>
              </a:ext>
            </a:extLst>
          </p:cNvPr>
          <p:cNvCxnSpPr>
            <a:cxnSpLocks/>
          </p:cNvCxnSpPr>
          <p:nvPr/>
        </p:nvCxnSpPr>
        <p:spPr>
          <a:xfrm>
            <a:off x="2152280" y="4251693"/>
            <a:ext cx="417616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4AEA7412-BAED-639F-97C0-9C10446EE86F}"/>
              </a:ext>
            </a:extLst>
          </p:cNvPr>
          <p:cNvSpPr txBox="1"/>
          <p:nvPr/>
        </p:nvSpPr>
        <p:spPr>
          <a:xfrm>
            <a:off x="2081834" y="4274690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G401</a:t>
            </a:r>
            <a:endParaRPr kumimoji="1" lang="ja-US" altLang="en-US" sz="1200" dirty="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E414077E-4AC1-8875-66EC-CD5B792095A0}"/>
              </a:ext>
            </a:extLst>
          </p:cNvPr>
          <p:cNvSpPr txBox="1"/>
          <p:nvPr/>
        </p:nvSpPr>
        <p:spPr>
          <a:xfrm>
            <a:off x="2637092" y="4262768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JMU</a:t>
            </a:r>
            <a:endParaRPr kumimoji="1" lang="ja-US" altLang="en-US" sz="1200" dirty="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39E8C70F-F1B6-0BB7-0C6D-30531232F015}"/>
              </a:ext>
            </a:extLst>
          </p:cNvPr>
          <p:cNvSpPr txBox="1"/>
          <p:nvPr/>
        </p:nvSpPr>
        <p:spPr>
          <a:xfrm>
            <a:off x="2075762" y="3991198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C</a:t>
            </a:r>
            <a:endParaRPr kumimoji="1" lang="ja-US" altLang="en-US" sz="1200" dirty="0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2ABF5814-9315-5889-7DA1-98594C3E8BE0}"/>
              </a:ext>
            </a:extLst>
          </p:cNvPr>
          <p:cNvSpPr txBox="1"/>
          <p:nvPr/>
        </p:nvSpPr>
        <p:spPr>
          <a:xfrm>
            <a:off x="2382366" y="3991199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O</a:t>
            </a:r>
            <a:endParaRPr kumimoji="1" lang="ja-US" altLang="en-US" sz="1200" dirty="0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9F5ECD24-C575-C274-3ED7-B3BDBF8525FD}"/>
              </a:ext>
            </a:extLst>
          </p:cNvPr>
          <p:cNvSpPr txBox="1"/>
          <p:nvPr/>
        </p:nvSpPr>
        <p:spPr>
          <a:xfrm>
            <a:off x="2865071" y="4008063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O</a:t>
            </a:r>
            <a:endParaRPr kumimoji="1" lang="ja-US" altLang="en-US" sz="1200" dirty="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F5D422A9-B361-7683-B585-4D82C8E7A363}"/>
              </a:ext>
            </a:extLst>
          </p:cNvPr>
          <p:cNvSpPr txBox="1"/>
          <p:nvPr/>
        </p:nvSpPr>
        <p:spPr>
          <a:xfrm>
            <a:off x="2649183" y="3996736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C</a:t>
            </a:r>
            <a:endParaRPr kumimoji="1" lang="ja-US" altLang="en-US" sz="1200" dirty="0"/>
          </a:p>
        </p:txBody>
      </p:sp>
      <p:cxnSp>
        <p:nvCxnSpPr>
          <p:cNvPr id="74" name="直線コネクタ 73">
            <a:extLst>
              <a:ext uri="{FF2B5EF4-FFF2-40B4-BE49-F238E27FC236}">
                <a16:creationId xmlns:a16="http://schemas.microsoft.com/office/drawing/2014/main" id="{554B11CD-CE24-D681-8318-6C197BAC615C}"/>
              </a:ext>
            </a:extLst>
          </p:cNvPr>
          <p:cNvCxnSpPr>
            <a:cxnSpLocks/>
          </p:cNvCxnSpPr>
          <p:nvPr/>
        </p:nvCxnSpPr>
        <p:spPr>
          <a:xfrm>
            <a:off x="2656875" y="4251693"/>
            <a:ext cx="417616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直線コネクタ 74">
            <a:extLst>
              <a:ext uri="{FF2B5EF4-FFF2-40B4-BE49-F238E27FC236}">
                <a16:creationId xmlns:a16="http://schemas.microsoft.com/office/drawing/2014/main" id="{3030D1E5-2BF3-E2A2-54C5-C0B4A0EDD348}"/>
              </a:ext>
            </a:extLst>
          </p:cNvPr>
          <p:cNvCxnSpPr>
            <a:cxnSpLocks/>
          </p:cNvCxnSpPr>
          <p:nvPr/>
        </p:nvCxnSpPr>
        <p:spPr>
          <a:xfrm>
            <a:off x="3122418" y="4099751"/>
            <a:ext cx="1027270" cy="1554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右矢印 75">
            <a:extLst>
              <a:ext uri="{FF2B5EF4-FFF2-40B4-BE49-F238E27FC236}">
                <a16:creationId xmlns:a16="http://schemas.microsoft.com/office/drawing/2014/main" id="{A5B679E7-CC90-A1E2-88B4-C8C1980D091B}"/>
              </a:ext>
            </a:extLst>
          </p:cNvPr>
          <p:cNvSpPr/>
          <p:nvPr/>
        </p:nvSpPr>
        <p:spPr>
          <a:xfrm rot="10800000">
            <a:off x="5235767" y="3944769"/>
            <a:ext cx="234598" cy="4571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CA763891-2B4A-706F-ABEF-01375E281DE3}"/>
              </a:ext>
            </a:extLst>
          </p:cNvPr>
          <p:cNvCxnSpPr>
            <a:cxnSpLocks/>
          </p:cNvCxnSpPr>
          <p:nvPr/>
        </p:nvCxnSpPr>
        <p:spPr>
          <a:xfrm>
            <a:off x="4211390" y="4539767"/>
            <a:ext cx="8989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23270CFD-B1CF-31B9-0FF3-18A1E985C94E}"/>
              </a:ext>
            </a:extLst>
          </p:cNvPr>
          <p:cNvSpPr txBox="1"/>
          <p:nvPr/>
        </p:nvSpPr>
        <p:spPr>
          <a:xfrm>
            <a:off x="4228970" y="4556648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Figure 2D </a:t>
            </a:r>
            <a:endParaRPr kumimoji="1" lang="ja-US" altLang="en-US" sz="1200" dirty="0"/>
          </a:p>
        </p:txBody>
      </p: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D3E89E5C-0F7E-393D-C61B-24F6C0601E35}"/>
              </a:ext>
            </a:extLst>
          </p:cNvPr>
          <p:cNvCxnSpPr>
            <a:cxnSpLocks/>
          </p:cNvCxnSpPr>
          <p:nvPr/>
        </p:nvCxnSpPr>
        <p:spPr>
          <a:xfrm>
            <a:off x="4211390" y="4251693"/>
            <a:ext cx="417616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7AC40DE4-A3BC-FB72-5826-F0B78929191D}"/>
              </a:ext>
            </a:extLst>
          </p:cNvPr>
          <p:cNvSpPr txBox="1"/>
          <p:nvPr/>
        </p:nvSpPr>
        <p:spPr>
          <a:xfrm>
            <a:off x="4145039" y="4016637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C</a:t>
            </a:r>
            <a:endParaRPr kumimoji="1" lang="ja-US" altLang="en-US" sz="1200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3517724D-C80C-B251-347C-6EF0DBA4B3CA}"/>
              </a:ext>
            </a:extLst>
          </p:cNvPr>
          <p:cNvSpPr txBox="1"/>
          <p:nvPr/>
        </p:nvSpPr>
        <p:spPr>
          <a:xfrm>
            <a:off x="4371504" y="4017661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O</a:t>
            </a:r>
            <a:endParaRPr kumimoji="1" lang="ja-US" altLang="en-US" sz="1200" dirty="0"/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13C17EE7-4FAF-9572-79AC-B3A6F4A5A573}"/>
              </a:ext>
            </a:extLst>
          </p:cNvPr>
          <p:cNvSpPr txBox="1"/>
          <p:nvPr/>
        </p:nvSpPr>
        <p:spPr>
          <a:xfrm>
            <a:off x="4869379" y="4023562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O</a:t>
            </a:r>
            <a:endParaRPr kumimoji="1" lang="ja-US" altLang="en-US" sz="1200" dirty="0"/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F7A38978-CCBD-EB1C-17A2-AEE8B817DE5E}"/>
              </a:ext>
            </a:extLst>
          </p:cNvPr>
          <p:cNvSpPr txBox="1"/>
          <p:nvPr/>
        </p:nvSpPr>
        <p:spPr>
          <a:xfrm>
            <a:off x="4590998" y="4021932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C</a:t>
            </a:r>
            <a:endParaRPr kumimoji="1" lang="ja-US" altLang="en-US" sz="1200" dirty="0"/>
          </a:p>
        </p:txBody>
      </p: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C0580AF3-2081-3C90-626E-8ECC13F4C199}"/>
              </a:ext>
            </a:extLst>
          </p:cNvPr>
          <p:cNvCxnSpPr>
            <a:cxnSpLocks/>
          </p:cNvCxnSpPr>
          <p:nvPr/>
        </p:nvCxnSpPr>
        <p:spPr>
          <a:xfrm>
            <a:off x="4668590" y="4252302"/>
            <a:ext cx="417616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7C130CF6-928B-3444-8383-858F86470831}"/>
              </a:ext>
            </a:extLst>
          </p:cNvPr>
          <p:cNvSpPr txBox="1"/>
          <p:nvPr/>
        </p:nvSpPr>
        <p:spPr>
          <a:xfrm>
            <a:off x="4642297" y="4274122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JMU</a:t>
            </a:r>
            <a:endParaRPr kumimoji="1" lang="ja-US" altLang="en-US" sz="1200" dirty="0"/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B81FED22-16E2-0E7F-A3B1-E64E7F3DC0B3}"/>
              </a:ext>
            </a:extLst>
          </p:cNvPr>
          <p:cNvSpPr txBox="1"/>
          <p:nvPr/>
        </p:nvSpPr>
        <p:spPr>
          <a:xfrm>
            <a:off x="4134674" y="4274690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G401</a:t>
            </a:r>
            <a:endParaRPr kumimoji="1" lang="ja-US" altLang="en-US" sz="1200" dirty="0"/>
          </a:p>
        </p:txBody>
      </p:sp>
      <p:sp>
        <p:nvSpPr>
          <p:cNvPr id="89" name="右矢印 88">
            <a:extLst>
              <a:ext uri="{FF2B5EF4-FFF2-40B4-BE49-F238E27FC236}">
                <a16:creationId xmlns:a16="http://schemas.microsoft.com/office/drawing/2014/main" id="{03110A9B-E39A-5CC4-3DB7-410660CDF71A}"/>
              </a:ext>
            </a:extLst>
          </p:cNvPr>
          <p:cNvSpPr/>
          <p:nvPr/>
        </p:nvSpPr>
        <p:spPr>
          <a:xfrm rot="10800000">
            <a:off x="9594741" y="900271"/>
            <a:ext cx="234598" cy="4571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  <p:sp>
        <p:nvSpPr>
          <p:cNvPr id="90" name="右矢印 89">
            <a:extLst>
              <a:ext uri="{FF2B5EF4-FFF2-40B4-BE49-F238E27FC236}">
                <a16:creationId xmlns:a16="http://schemas.microsoft.com/office/drawing/2014/main" id="{F07F5392-9E99-FA21-D4D4-56AED75B125D}"/>
              </a:ext>
            </a:extLst>
          </p:cNvPr>
          <p:cNvSpPr/>
          <p:nvPr/>
        </p:nvSpPr>
        <p:spPr>
          <a:xfrm rot="10800000">
            <a:off x="9395455" y="4638462"/>
            <a:ext cx="234598" cy="45719"/>
          </a:xfrm>
          <a:prstGeom prst="rightArrow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US" altLang="en-US"/>
          </a:p>
        </p:txBody>
      </p:sp>
      <p:cxnSp>
        <p:nvCxnSpPr>
          <p:cNvPr id="92" name="直線コネクタ 91">
            <a:extLst>
              <a:ext uri="{FF2B5EF4-FFF2-40B4-BE49-F238E27FC236}">
                <a16:creationId xmlns:a16="http://schemas.microsoft.com/office/drawing/2014/main" id="{1B2C7460-D15A-77D6-A3AD-18E779B6E9A4}"/>
              </a:ext>
            </a:extLst>
          </p:cNvPr>
          <p:cNvCxnSpPr>
            <a:cxnSpLocks/>
          </p:cNvCxnSpPr>
          <p:nvPr/>
        </p:nvCxnSpPr>
        <p:spPr>
          <a:xfrm>
            <a:off x="6380912" y="1131721"/>
            <a:ext cx="1928991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78A82FB8-2255-1FFD-B54D-AF9CBC9F10EA}"/>
              </a:ext>
            </a:extLst>
          </p:cNvPr>
          <p:cNvSpPr txBox="1"/>
          <p:nvPr/>
        </p:nvSpPr>
        <p:spPr>
          <a:xfrm>
            <a:off x="6973106" y="1130720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Unused</a:t>
            </a:r>
            <a:endParaRPr kumimoji="1" lang="ja-US" altLang="en-US" sz="1200" dirty="0"/>
          </a:p>
        </p:txBody>
      </p:sp>
      <p:cxnSp>
        <p:nvCxnSpPr>
          <p:cNvPr id="97" name="直線コネクタ 96">
            <a:extLst>
              <a:ext uri="{FF2B5EF4-FFF2-40B4-BE49-F238E27FC236}">
                <a16:creationId xmlns:a16="http://schemas.microsoft.com/office/drawing/2014/main" id="{6CDA2D08-94A8-6AC3-AB1D-D74E5A70A0F0}"/>
              </a:ext>
            </a:extLst>
          </p:cNvPr>
          <p:cNvCxnSpPr>
            <a:cxnSpLocks/>
          </p:cNvCxnSpPr>
          <p:nvPr/>
        </p:nvCxnSpPr>
        <p:spPr>
          <a:xfrm>
            <a:off x="8484162" y="1511131"/>
            <a:ext cx="8989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82275807-968F-679F-D5F8-886CE07A25DE}"/>
              </a:ext>
            </a:extLst>
          </p:cNvPr>
          <p:cNvSpPr txBox="1"/>
          <p:nvPr/>
        </p:nvSpPr>
        <p:spPr>
          <a:xfrm>
            <a:off x="8501742" y="1528012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Figure 2D </a:t>
            </a:r>
            <a:endParaRPr kumimoji="1" lang="ja-US" altLang="en-US" sz="1200" dirty="0"/>
          </a:p>
        </p:txBody>
      </p:sp>
      <p:cxnSp>
        <p:nvCxnSpPr>
          <p:cNvPr id="99" name="直線コネクタ 98">
            <a:extLst>
              <a:ext uri="{FF2B5EF4-FFF2-40B4-BE49-F238E27FC236}">
                <a16:creationId xmlns:a16="http://schemas.microsoft.com/office/drawing/2014/main" id="{45AACF29-B8CB-85BE-57EE-2DCC299ACA67}"/>
              </a:ext>
            </a:extLst>
          </p:cNvPr>
          <p:cNvCxnSpPr>
            <a:cxnSpLocks/>
          </p:cNvCxnSpPr>
          <p:nvPr/>
        </p:nvCxnSpPr>
        <p:spPr>
          <a:xfrm>
            <a:off x="8484162" y="1223057"/>
            <a:ext cx="417616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0" name="テキスト ボックス 99">
            <a:extLst>
              <a:ext uri="{FF2B5EF4-FFF2-40B4-BE49-F238E27FC236}">
                <a16:creationId xmlns:a16="http://schemas.microsoft.com/office/drawing/2014/main" id="{E42E4D5C-56AD-BE47-7FF8-8E32C8372B52}"/>
              </a:ext>
            </a:extLst>
          </p:cNvPr>
          <p:cNvSpPr txBox="1"/>
          <p:nvPr/>
        </p:nvSpPr>
        <p:spPr>
          <a:xfrm>
            <a:off x="8417811" y="988001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C</a:t>
            </a:r>
            <a:endParaRPr kumimoji="1" lang="ja-US" altLang="en-US" sz="1200" dirty="0"/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8165C4F9-3696-C468-E72D-6A762A040852}"/>
              </a:ext>
            </a:extLst>
          </p:cNvPr>
          <p:cNvSpPr txBox="1"/>
          <p:nvPr/>
        </p:nvSpPr>
        <p:spPr>
          <a:xfrm>
            <a:off x="8644276" y="989025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O</a:t>
            </a:r>
            <a:endParaRPr kumimoji="1" lang="ja-US" altLang="en-US" sz="1200" dirty="0"/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CA207F98-0A16-75D8-0869-AB889BFA36E6}"/>
              </a:ext>
            </a:extLst>
          </p:cNvPr>
          <p:cNvSpPr txBox="1"/>
          <p:nvPr/>
        </p:nvSpPr>
        <p:spPr>
          <a:xfrm>
            <a:off x="9142151" y="994926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O</a:t>
            </a:r>
            <a:endParaRPr kumimoji="1" lang="ja-US" altLang="en-US" sz="1200" dirty="0"/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A8699EA9-E07F-E715-34C9-33F83DC45F0A}"/>
              </a:ext>
            </a:extLst>
          </p:cNvPr>
          <p:cNvSpPr txBox="1"/>
          <p:nvPr/>
        </p:nvSpPr>
        <p:spPr>
          <a:xfrm>
            <a:off x="8863770" y="993296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C</a:t>
            </a:r>
            <a:endParaRPr kumimoji="1" lang="ja-US" altLang="en-US" sz="1200" dirty="0"/>
          </a:p>
        </p:txBody>
      </p:sp>
      <p:cxnSp>
        <p:nvCxnSpPr>
          <p:cNvPr id="104" name="直線コネクタ 103">
            <a:extLst>
              <a:ext uri="{FF2B5EF4-FFF2-40B4-BE49-F238E27FC236}">
                <a16:creationId xmlns:a16="http://schemas.microsoft.com/office/drawing/2014/main" id="{B06AC8E4-480D-E1DC-8B3B-B0DEA4BFC114}"/>
              </a:ext>
            </a:extLst>
          </p:cNvPr>
          <p:cNvCxnSpPr>
            <a:cxnSpLocks/>
          </p:cNvCxnSpPr>
          <p:nvPr/>
        </p:nvCxnSpPr>
        <p:spPr>
          <a:xfrm>
            <a:off x="8941362" y="1223666"/>
            <a:ext cx="417616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E8C2B72D-DA02-C0DE-5D5A-FA5348C84D20}"/>
              </a:ext>
            </a:extLst>
          </p:cNvPr>
          <p:cNvSpPr txBox="1"/>
          <p:nvPr/>
        </p:nvSpPr>
        <p:spPr>
          <a:xfrm>
            <a:off x="8407446" y="1246054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G401</a:t>
            </a:r>
            <a:endParaRPr kumimoji="1" lang="ja-US" altLang="en-US" sz="1200" dirty="0"/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90868D7E-B2BB-7332-DF10-44DCEE9F3CBE}"/>
              </a:ext>
            </a:extLst>
          </p:cNvPr>
          <p:cNvSpPr txBox="1"/>
          <p:nvPr/>
        </p:nvSpPr>
        <p:spPr>
          <a:xfrm>
            <a:off x="8923271" y="1240093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JMU</a:t>
            </a:r>
            <a:endParaRPr kumimoji="1" lang="ja-US" altLang="en-US" sz="1200" dirty="0"/>
          </a:p>
        </p:txBody>
      </p:sp>
      <p:cxnSp>
        <p:nvCxnSpPr>
          <p:cNvPr id="108" name="直線コネクタ 107">
            <a:extLst>
              <a:ext uri="{FF2B5EF4-FFF2-40B4-BE49-F238E27FC236}">
                <a16:creationId xmlns:a16="http://schemas.microsoft.com/office/drawing/2014/main" id="{0938C8B9-3926-A125-F663-42B9C0EE4904}"/>
              </a:ext>
            </a:extLst>
          </p:cNvPr>
          <p:cNvCxnSpPr>
            <a:cxnSpLocks/>
          </p:cNvCxnSpPr>
          <p:nvPr/>
        </p:nvCxnSpPr>
        <p:spPr>
          <a:xfrm>
            <a:off x="8450225" y="5469259"/>
            <a:ext cx="898995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CA00D1D5-9A9F-CE5C-CACD-3F132E78E19B}"/>
              </a:ext>
            </a:extLst>
          </p:cNvPr>
          <p:cNvSpPr txBox="1"/>
          <p:nvPr/>
        </p:nvSpPr>
        <p:spPr>
          <a:xfrm>
            <a:off x="8467805" y="5486140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Figure 2D </a:t>
            </a:r>
            <a:endParaRPr kumimoji="1" lang="ja-US" altLang="en-US" sz="1200" dirty="0"/>
          </a:p>
        </p:txBody>
      </p:sp>
      <p:cxnSp>
        <p:nvCxnSpPr>
          <p:cNvPr id="110" name="直線コネクタ 109">
            <a:extLst>
              <a:ext uri="{FF2B5EF4-FFF2-40B4-BE49-F238E27FC236}">
                <a16:creationId xmlns:a16="http://schemas.microsoft.com/office/drawing/2014/main" id="{A8F06F3A-CC53-16D3-31D2-4F1878B8D691}"/>
              </a:ext>
            </a:extLst>
          </p:cNvPr>
          <p:cNvCxnSpPr>
            <a:cxnSpLocks/>
          </p:cNvCxnSpPr>
          <p:nvPr/>
        </p:nvCxnSpPr>
        <p:spPr>
          <a:xfrm>
            <a:off x="8450225" y="5181185"/>
            <a:ext cx="417616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3E760F8C-040D-76B8-F8A9-279CA2941932}"/>
              </a:ext>
            </a:extLst>
          </p:cNvPr>
          <p:cNvSpPr txBox="1"/>
          <p:nvPr/>
        </p:nvSpPr>
        <p:spPr>
          <a:xfrm>
            <a:off x="8383874" y="4946129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C</a:t>
            </a:r>
            <a:endParaRPr kumimoji="1" lang="ja-US" altLang="en-US" sz="1200" dirty="0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D0DF8B3C-9965-E00B-5FC1-0B7DF2F224DD}"/>
              </a:ext>
            </a:extLst>
          </p:cNvPr>
          <p:cNvSpPr txBox="1"/>
          <p:nvPr/>
        </p:nvSpPr>
        <p:spPr>
          <a:xfrm>
            <a:off x="8610339" y="4947153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O</a:t>
            </a:r>
            <a:endParaRPr kumimoji="1" lang="ja-US" altLang="en-US" sz="1200" dirty="0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6ADEC4BD-200E-3C23-5BF5-03AD77E76F45}"/>
              </a:ext>
            </a:extLst>
          </p:cNvPr>
          <p:cNvSpPr txBox="1"/>
          <p:nvPr/>
        </p:nvSpPr>
        <p:spPr>
          <a:xfrm>
            <a:off x="9108214" y="4953054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O</a:t>
            </a:r>
            <a:endParaRPr kumimoji="1" lang="ja-US" altLang="en-US" sz="1200" dirty="0"/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35CD2F38-2C86-CD68-D9C8-D86C422A19B0}"/>
              </a:ext>
            </a:extLst>
          </p:cNvPr>
          <p:cNvSpPr txBox="1"/>
          <p:nvPr/>
        </p:nvSpPr>
        <p:spPr>
          <a:xfrm>
            <a:off x="8829833" y="4951424"/>
            <a:ext cx="3385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C</a:t>
            </a:r>
            <a:endParaRPr kumimoji="1" lang="ja-US" altLang="en-US" sz="1200" dirty="0"/>
          </a:p>
        </p:txBody>
      </p:sp>
      <p:cxnSp>
        <p:nvCxnSpPr>
          <p:cNvPr id="115" name="直線コネクタ 114">
            <a:extLst>
              <a:ext uri="{FF2B5EF4-FFF2-40B4-BE49-F238E27FC236}">
                <a16:creationId xmlns:a16="http://schemas.microsoft.com/office/drawing/2014/main" id="{96665D04-42BF-1527-1527-35DA878CBD64}"/>
              </a:ext>
            </a:extLst>
          </p:cNvPr>
          <p:cNvCxnSpPr>
            <a:cxnSpLocks/>
          </p:cNvCxnSpPr>
          <p:nvPr/>
        </p:nvCxnSpPr>
        <p:spPr>
          <a:xfrm>
            <a:off x="8907425" y="5181794"/>
            <a:ext cx="417616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EB1161B9-35C6-07EB-CB07-48F8EF60C363}"/>
              </a:ext>
            </a:extLst>
          </p:cNvPr>
          <p:cNvSpPr txBox="1"/>
          <p:nvPr/>
        </p:nvSpPr>
        <p:spPr>
          <a:xfrm>
            <a:off x="8373509" y="5204182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G401</a:t>
            </a:r>
            <a:endParaRPr kumimoji="1" lang="ja-US" altLang="en-US" sz="1200" dirty="0"/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A96B47CF-4F0C-6738-3715-1424FB2282E1}"/>
              </a:ext>
            </a:extLst>
          </p:cNvPr>
          <p:cNvSpPr txBox="1"/>
          <p:nvPr/>
        </p:nvSpPr>
        <p:spPr>
          <a:xfrm>
            <a:off x="8889334" y="5198221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JMU</a:t>
            </a:r>
            <a:endParaRPr kumimoji="1" lang="ja-US" altLang="en-US" sz="1200" dirty="0"/>
          </a:p>
        </p:txBody>
      </p:sp>
      <p:cxnSp>
        <p:nvCxnSpPr>
          <p:cNvPr id="118" name="直線コネクタ 117">
            <a:extLst>
              <a:ext uri="{FF2B5EF4-FFF2-40B4-BE49-F238E27FC236}">
                <a16:creationId xmlns:a16="http://schemas.microsoft.com/office/drawing/2014/main" id="{7B59A36D-B9A4-699C-FA99-E2BC5CDBE2A3}"/>
              </a:ext>
            </a:extLst>
          </p:cNvPr>
          <p:cNvCxnSpPr>
            <a:cxnSpLocks/>
          </p:cNvCxnSpPr>
          <p:nvPr/>
        </p:nvCxnSpPr>
        <p:spPr>
          <a:xfrm>
            <a:off x="6731000" y="5067708"/>
            <a:ext cx="1676446" cy="0"/>
          </a:xfrm>
          <a:prstGeom prst="line">
            <a:avLst/>
          </a:prstGeom>
          <a:ln w="38100"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BA200E13-4707-C12F-07D8-FDDAD4007F3D}"/>
              </a:ext>
            </a:extLst>
          </p:cNvPr>
          <p:cNvSpPr txBox="1"/>
          <p:nvPr/>
        </p:nvSpPr>
        <p:spPr>
          <a:xfrm>
            <a:off x="7250889" y="5074365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Unused</a:t>
            </a:r>
            <a:endParaRPr kumimoji="1" lang="ja-US" altLang="en-US" sz="1200" dirty="0"/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F8D8FC43-B039-58CE-48C4-148FC439E467}"/>
              </a:ext>
            </a:extLst>
          </p:cNvPr>
          <p:cNvSpPr txBox="1"/>
          <p:nvPr/>
        </p:nvSpPr>
        <p:spPr>
          <a:xfrm>
            <a:off x="5613543" y="753603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40</a:t>
            </a:r>
            <a:endParaRPr kumimoji="1" lang="ja-US" altLang="en-US" sz="1200" dirty="0"/>
          </a:p>
        </p:txBody>
      </p:sp>
      <p:cxnSp>
        <p:nvCxnSpPr>
          <p:cNvPr id="123" name="直線コネクタ 122">
            <a:extLst>
              <a:ext uri="{FF2B5EF4-FFF2-40B4-BE49-F238E27FC236}">
                <a16:creationId xmlns:a16="http://schemas.microsoft.com/office/drawing/2014/main" id="{7388721A-8A6E-73B3-73C5-4588C78A3B1B}"/>
              </a:ext>
            </a:extLst>
          </p:cNvPr>
          <p:cNvCxnSpPr>
            <a:cxnSpLocks/>
          </p:cNvCxnSpPr>
          <p:nvPr/>
        </p:nvCxnSpPr>
        <p:spPr>
          <a:xfrm flipH="1">
            <a:off x="5973295" y="885755"/>
            <a:ext cx="148105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42A0E624-89D9-CCC9-5184-15DF91000585}"/>
              </a:ext>
            </a:extLst>
          </p:cNvPr>
          <p:cNvSpPr txBox="1"/>
          <p:nvPr/>
        </p:nvSpPr>
        <p:spPr>
          <a:xfrm>
            <a:off x="5727798" y="347375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 err="1"/>
              <a:t>kDa</a:t>
            </a:r>
            <a:endParaRPr kumimoji="1" lang="ja-US" altLang="en-US" sz="1200" dirty="0"/>
          </a:p>
        </p:txBody>
      </p:sp>
      <p:cxnSp>
        <p:nvCxnSpPr>
          <p:cNvPr id="133" name="直線コネクタ 132">
            <a:extLst>
              <a:ext uri="{FF2B5EF4-FFF2-40B4-BE49-F238E27FC236}">
                <a16:creationId xmlns:a16="http://schemas.microsoft.com/office/drawing/2014/main" id="{2F32E918-DBF0-FD9B-2F16-77B7EA5FF813}"/>
              </a:ext>
            </a:extLst>
          </p:cNvPr>
          <p:cNvCxnSpPr>
            <a:cxnSpLocks/>
          </p:cNvCxnSpPr>
          <p:nvPr/>
        </p:nvCxnSpPr>
        <p:spPr>
          <a:xfrm flipH="1">
            <a:off x="5973295" y="1095325"/>
            <a:ext cx="148105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FF2D9549-08B9-FA98-DA9D-041EB5594AA7}"/>
              </a:ext>
            </a:extLst>
          </p:cNvPr>
          <p:cNvSpPr txBox="1"/>
          <p:nvPr/>
        </p:nvSpPr>
        <p:spPr>
          <a:xfrm>
            <a:off x="5613489" y="963796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00</a:t>
            </a:r>
            <a:endParaRPr kumimoji="1" lang="ja-US" altLang="en-US" sz="1200" dirty="0"/>
          </a:p>
        </p:txBody>
      </p:sp>
      <p:cxnSp>
        <p:nvCxnSpPr>
          <p:cNvPr id="135" name="直線コネクタ 134">
            <a:extLst>
              <a:ext uri="{FF2B5EF4-FFF2-40B4-BE49-F238E27FC236}">
                <a16:creationId xmlns:a16="http://schemas.microsoft.com/office/drawing/2014/main" id="{B0008ADC-3A3C-8DB8-A3F7-D979B669E5CF}"/>
              </a:ext>
            </a:extLst>
          </p:cNvPr>
          <p:cNvCxnSpPr>
            <a:cxnSpLocks/>
          </p:cNvCxnSpPr>
          <p:nvPr/>
        </p:nvCxnSpPr>
        <p:spPr>
          <a:xfrm flipH="1">
            <a:off x="5960595" y="707955"/>
            <a:ext cx="148105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A51CC1AA-7CC5-D37A-2DB3-8878A4F1DA3C}"/>
              </a:ext>
            </a:extLst>
          </p:cNvPr>
          <p:cNvSpPr txBox="1"/>
          <p:nvPr/>
        </p:nvSpPr>
        <p:spPr>
          <a:xfrm>
            <a:off x="5613543" y="567016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260</a:t>
            </a:r>
            <a:endParaRPr kumimoji="1" lang="ja-US" altLang="en-US" sz="1200" dirty="0"/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CD75E4E2-DA0F-3624-6D5A-2BDE7F28FEC1}"/>
              </a:ext>
            </a:extLst>
          </p:cNvPr>
          <p:cNvSpPr txBox="1"/>
          <p:nvPr/>
        </p:nvSpPr>
        <p:spPr>
          <a:xfrm>
            <a:off x="5881532" y="4535581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40</a:t>
            </a:r>
            <a:endParaRPr kumimoji="1" lang="ja-US" altLang="en-US" sz="1200" dirty="0"/>
          </a:p>
        </p:txBody>
      </p:sp>
      <p:cxnSp>
        <p:nvCxnSpPr>
          <p:cNvPr id="138" name="直線コネクタ 137">
            <a:extLst>
              <a:ext uri="{FF2B5EF4-FFF2-40B4-BE49-F238E27FC236}">
                <a16:creationId xmlns:a16="http://schemas.microsoft.com/office/drawing/2014/main" id="{106DAFDD-FE40-F84B-5EA2-B903CC1E8A55}"/>
              </a:ext>
            </a:extLst>
          </p:cNvPr>
          <p:cNvCxnSpPr>
            <a:cxnSpLocks/>
          </p:cNvCxnSpPr>
          <p:nvPr/>
        </p:nvCxnSpPr>
        <p:spPr>
          <a:xfrm flipH="1">
            <a:off x="6241284" y="4667733"/>
            <a:ext cx="148105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0013C57D-7586-53F7-9126-294171721521}"/>
              </a:ext>
            </a:extLst>
          </p:cNvPr>
          <p:cNvSpPr txBox="1"/>
          <p:nvPr/>
        </p:nvSpPr>
        <p:spPr>
          <a:xfrm>
            <a:off x="5995787" y="4129353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 err="1"/>
              <a:t>kDa</a:t>
            </a:r>
            <a:endParaRPr kumimoji="1" lang="ja-US" altLang="en-US" sz="1200" dirty="0"/>
          </a:p>
        </p:txBody>
      </p:sp>
      <p:cxnSp>
        <p:nvCxnSpPr>
          <p:cNvPr id="140" name="直線コネクタ 139">
            <a:extLst>
              <a:ext uri="{FF2B5EF4-FFF2-40B4-BE49-F238E27FC236}">
                <a16:creationId xmlns:a16="http://schemas.microsoft.com/office/drawing/2014/main" id="{3C7FFB5D-A9D7-3E75-EEEA-51E4A41BC6DE}"/>
              </a:ext>
            </a:extLst>
          </p:cNvPr>
          <p:cNvCxnSpPr>
            <a:cxnSpLocks/>
          </p:cNvCxnSpPr>
          <p:nvPr/>
        </p:nvCxnSpPr>
        <p:spPr>
          <a:xfrm flipH="1">
            <a:off x="6241284" y="4877303"/>
            <a:ext cx="148105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8BED5FFD-45C3-ADC6-9AEC-AFE8B9A63573}"/>
              </a:ext>
            </a:extLst>
          </p:cNvPr>
          <p:cNvSpPr txBox="1"/>
          <p:nvPr/>
        </p:nvSpPr>
        <p:spPr>
          <a:xfrm>
            <a:off x="5881478" y="4745774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00</a:t>
            </a:r>
            <a:endParaRPr kumimoji="1" lang="ja-US" altLang="en-US" sz="1200" dirty="0"/>
          </a:p>
        </p:txBody>
      </p:sp>
      <p:cxnSp>
        <p:nvCxnSpPr>
          <p:cNvPr id="142" name="直線コネクタ 141">
            <a:extLst>
              <a:ext uri="{FF2B5EF4-FFF2-40B4-BE49-F238E27FC236}">
                <a16:creationId xmlns:a16="http://schemas.microsoft.com/office/drawing/2014/main" id="{9DAC119C-2A2C-4953-4D4F-140DF085B4F3}"/>
              </a:ext>
            </a:extLst>
          </p:cNvPr>
          <p:cNvCxnSpPr>
            <a:cxnSpLocks/>
          </p:cNvCxnSpPr>
          <p:nvPr/>
        </p:nvCxnSpPr>
        <p:spPr>
          <a:xfrm flipH="1">
            <a:off x="6228584" y="4489933"/>
            <a:ext cx="148105" cy="0"/>
          </a:xfrm>
          <a:prstGeom prst="line">
            <a:avLst/>
          </a:prstGeom>
          <a:ln w="28575"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4FFF23B1-2D60-039A-13EC-7A66156C0FC6}"/>
              </a:ext>
            </a:extLst>
          </p:cNvPr>
          <p:cNvSpPr txBox="1"/>
          <p:nvPr/>
        </p:nvSpPr>
        <p:spPr>
          <a:xfrm>
            <a:off x="5881532" y="4348994"/>
            <a:ext cx="536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260</a:t>
            </a:r>
            <a:endParaRPr kumimoji="1" lang="ja-US" altLang="en-US" sz="1200" dirty="0"/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C7783758-6E3A-4243-24A5-8841BDC9A101}"/>
              </a:ext>
            </a:extLst>
          </p:cNvPr>
          <p:cNvSpPr txBox="1"/>
          <p:nvPr/>
        </p:nvSpPr>
        <p:spPr>
          <a:xfrm>
            <a:off x="2132576" y="1277655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311BB61C-3891-2289-AE8A-740B6254AED3}"/>
              </a:ext>
            </a:extLst>
          </p:cNvPr>
          <p:cNvSpPr txBox="1"/>
          <p:nvPr/>
        </p:nvSpPr>
        <p:spPr>
          <a:xfrm>
            <a:off x="2318680" y="1277655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2.6</a:t>
            </a:r>
            <a:endParaRPr kumimoji="1" lang="ja-US" altLang="en-US" sz="1200" dirty="0"/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E7EF84AB-A77A-6017-766F-35EDCF735193}"/>
              </a:ext>
            </a:extLst>
          </p:cNvPr>
          <p:cNvSpPr txBox="1"/>
          <p:nvPr/>
        </p:nvSpPr>
        <p:spPr>
          <a:xfrm>
            <a:off x="2557196" y="1277655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2.0</a:t>
            </a:r>
            <a:endParaRPr kumimoji="1" lang="ja-US" altLang="en-US" sz="1200" dirty="0"/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BFD5225A-5562-4809-0A54-ACFA9E9639E0}"/>
              </a:ext>
            </a:extLst>
          </p:cNvPr>
          <p:cNvSpPr txBox="1"/>
          <p:nvPr/>
        </p:nvSpPr>
        <p:spPr>
          <a:xfrm>
            <a:off x="2782815" y="1277838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3.8</a:t>
            </a:r>
            <a:endParaRPr kumimoji="1" lang="ja-US" altLang="en-US" sz="1200" dirty="0"/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CB5B488D-7744-5B16-7460-82334CB46E61}"/>
              </a:ext>
            </a:extLst>
          </p:cNvPr>
          <p:cNvSpPr txBox="1"/>
          <p:nvPr/>
        </p:nvSpPr>
        <p:spPr>
          <a:xfrm>
            <a:off x="2074229" y="3526132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149" name="テキスト ボックス 148">
            <a:extLst>
              <a:ext uri="{FF2B5EF4-FFF2-40B4-BE49-F238E27FC236}">
                <a16:creationId xmlns:a16="http://schemas.microsoft.com/office/drawing/2014/main" id="{0B4000F2-11B4-C089-586B-610063856269}"/>
              </a:ext>
            </a:extLst>
          </p:cNvPr>
          <p:cNvSpPr txBox="1"/>
          <p:nvPr/>
        </p:nvSpPr>
        <p:spPr>
          <a:xfrm>
            <a:off x="2312902" y="3520205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.1</a:t>
            </a:r>
            <a:endParaRPr kumimoji="1" lang="ja-US" altLang="en-US" sz="1200" dirty="0"/>
          </a:p>
        </p:txBody>
      </p:sp>
      <p:sp>
        <p:nvSpPr>
          <p:cNvPr id="150" name="テキスト ボックス 149">
            <a:extLst>
              <a:ext uri="{FF2B5EF4-FFF2-40B4-BE49-F238E27FC236}">
                <a16:creationId xmlns:a16="http://schemas.microsoft.com/office/drawing/2014/main" id="{AFD0F5A4-8130-0A1F-3F91-3F1C1ED9962A}"/>
              </a:ext>
            </a:extLst>
          </p:cNvPr>
          <p:cNvSpPr txBox="1"/>
          <p:nvPr/>
        </p:nvSpPr>
        <p:spPr>
          <a:xfrm>
            <a:off x="2586826" y="3520205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.1</a:t>
            </a:r>
            <a:endParaRPr kumimoji="1" lang="ja-US" altLang="en-US" sz="1200" dirty="0"/>
          </a:p>
        </p:txBody>
      </p:sp>
      <p:sp>
        <p:nvSpPr>
          <p:cNvPr id="151" name="テキスト ボックス 150">
            <a:extLst>
              <a:ext uri="{FF2B5EF4-FFF2-40B4-BE49-F238E27FC236}">
                <a16:creationId xmlns:a16="http://schemas.microsoft.com/office/drawing/2014/main" id="{3E700B8D-8B76-2F04-3C41-A40BF7EF83BA}"/>
              </a:ext>
            </a:extLst>
          </p:cNvPr>
          <p:cNvSpPr txBox="1"/>
          <p:nvPr/>
        </p:nvSpPr>
        <p:spPr>
          <a:xfrm>
            <a:off x="2863169" y="3528617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E282825B-196C-8C3A-DA52-8725C5D23097}"/>
              </a:ext>
            </a:extLst>
          </p:cNvPr>
          <p:cNvSpPr txBox="1"/>
          <p:nvPr/>
        </p:nvSpPr>
        <p:spPr>
          <a:xfrm>
            <a:off x="4113860" y="3502938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153" name="テキスト ボックス 152">
            <a:extLst>
              <a:ext uri="{FF2B5EF4-FFF2-40B4-BE49-F238E27FC236}">
                <a16:creationId xmlns:a16="http://schemas.microsoft.com/office/drawing/2014/main" id="{E806B969-A03E-199A-56DA-636046B64DB8}"/>
              </a:ext>
            </a:extLst>
          </p:cNvPr>
          <p:cNvSpPr txBox="1"/>
          <p:nvPr/>
        </p:nvSpPr>
        <p:spPr>
          <a:xfrm>
            <a:off x="4276825" y="3503460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.1</a:t>
            </a:r>
            <a:endParaRPr kumimoji="1" lang="ja-US" altLang="en-US" sz="1200" dirty="0"/>
          </a:p>
        </p:txBody>
      </p:sp>
      <p:sp>
        <p:nvSpPr>
          <p:cNvPr id="154" name="テキスト ボックス 153">
            <a:extLst>
              <a:ext uri="{FF2B5EF4-FFF2-40B4-BE49-F238E27FC236}">
                <a16:creationId xmlns:a16="http://schemas.microsoft.com/office/drawing/2014/main" id="{9158603C-A776-EA42-77BB-5F41C7E7A73F}"/>
              </a:ext>
            </a:extLst>
          </p:cNvPr>
          <p:cNvSpPr txBox="1"/>
          <p:nvPr/>
        </p:nvSpPr>
        <p:spPr>
          <a:xfrm>
            <a:off x="4534419" y="3503446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9</a:t>
            </a:r>
            <a:endParaRPr kumimoji="1" lang="ja-US" altLang="en-US" sz="1200" dirty="0"/>
          </a:p>
        </p:txBody>
      </p:sp>
      <p:sp>
        <p:nvSpPr>
          <p:cNvPr id="155" name="テキスト ボックス 154">
            <a:extLst>
              <a:ext uri="{FF2B5EF4-FFF2-40B4-BE49-F238E27FC236}">
                <a16:creationId xmlns:a16="http://schemas.microsoft.com/office/drawing/2014/main" id="{7E242BC9-F52F-3850-95B0-7F04E36B0CDB}"/>
              </a:ext>
            </a:extLst>
          </p:cNvPr>
          <p:cNvSpPr txBox="1"/>
          <p:nvPr/>
        </p:nvSpPr>
        <p:spPr>
          <a:xfrm>
            <a:off x="4812431" y="3503002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9</a:t>
            </a:r>
            <a:endParaRPr kumimoji="1" lang="ja-US" altLang="en-US" sz="1200" dirty="0"/>
          </a:p>
        </p:txBody>
      </p:sp>
      <p:sp>
        <p:nvSpPr>
          <p:cNvPr id="156" name="テキスト ボックス 155">
            <a:extLst>
              <a:ext uri="{FF2B5EF4-FFF2-40B4-BE49-F238E27FC236}">
                <a16:creationId xmlns:a16="http://schemas.microsoft.com/office/drawing/2014/main" id="{E18375B5-F936-9650-DD6F-A7E8CFAF1D0B}"/>
              </a:ext>
            </a:extLst>
          </p:cNvPr>
          <p:cNvSpPr txBox="1"/>
          <p:nvPr/>
        </p:nvSpPr>
        <p:spPr>
          <a:xfrm>
            <a:off x="8407433" y="504832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21851EA0-1FFA-38D1-5D67-9947B5B28058}"/>
              </a:ext>
            </a:extLst>
          </p:cNvPr>
          <p:cNvSpPr txBox="1"/>
          <p:nvPr/>
        </p:nvSpPr>
        <p:spPr>
          <a:xfrm>
            <a:off x="8573922" y="499760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5</a:t>
            </a:r>
            <a:endParaRPr kumimoji="1" lang="ja-US" altLang="en-US" sz="1200" dirty="0"/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393DADE2-441A-724B-8953-B825F6496B9F}"/>
              </a:ext>
            </a:extLst>
          </p:cNvPr>
          <p:cNvSpPr txBox="1"/>
          <p:nvPr/>
        </p:nvSpPr>
        <p:spPr>
          <a:xfrm>
            <a:off x="8824424" y="499760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9</a:t>
            </a:r>
            <a:endParaRPr kumimoji="1" lang="ja-US" altLang="en-US" sz="1200" dirty="0"/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C96A1864-AE06-0385-89B4-EAFF9F8F6975}"/>
              </a:ext>
            </a:extLst>
          </p:cNvPr>
          <p:cNvSpPr txBox="1"/>
          <p:nvPr/>
        </p:nvSpPr>
        <p:spPr>
          <a:xfrm>
            <a:off x="9105780" y="499760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2</a:t>
            </a:r>
            <a:endParaRPr kumimoji="1" lang="ja-US" altLang="en-US" sz="1200" dirty="0"/>
          </a:p>
        </p:txBody>
      </p:sp>
      <p:sp>
        <p:nvSpPr>
          <p:cNvPr id="160" name="テキスト ボックス 159">
            <a:extLst>
              <a:ext uri="{FF2B5EF4-FFF2-40B4-BE49-F238E27FC236}">
                <a16:creationId xmlns:a16="http://schemas.microsoft.com/office/drawing/2014/main" id="{4491EFFF-0ED0-A2D6-45FD-D300BCDEB2C5}"/>
              </a:ext>
            </a:extLst>
          </p:cNvPr>
          <p:cNvSpPr txBox="1"/>
          <p:nvPr/>
        </p:nvSpPr>
        <p:spPr>
          <a:xfrm>
            <a:off x="8398111" y="4326013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161" name="テキスト ボックス 160">
            <a:extLst>
              <a:ext uri="{FF2B5EF4-FFF2-40B4-BE49-F238E27FC236}">
                <a16:creationId xmlns:a16="http://schemas.microsoft.com/office/drawing/2014/main" id="{DA16ECCE-32B9-71E1-CD93-E776C335B7BA}"/>
              </a:ext>
            </a:extLst>
          </p:cNvPr>
          <p:cNvSpPr txBox="1"/>
          <p:nvPr/>
        </p:nvSpPr>
        <p:spPr>
          <a:xfrm>
            <a:off x="8628100" y="4320941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1</a:t>
            </a:r>
            <a:endParaRPr kumimoji="1" lang="ja-US" altLang="en-US" sz="1200" dirty="0"/>
          </a:p>
        </p:txBody>
      </p:sp>
      <p:sp>
        <p:nvSpPr>
          <p:cNvPr id="162" name="テキスト ボックス 161">
            <a:extLst>
              <a:ext uri="{FF2B5EF4-FFF2-40B4-BE49-F238E27FC236}">
                <a16:creationId xmlns:a16="http://schemas.microsoft.com/office/drawing/2014/main" id="{8B96123A-17DC-7F3F-35EF-DAF0F7749E8F}"/>
              </a:ext>
            </a:extLst>
          </p:cNvPr>
          <p:cNvSpPr txBox="1"/>
          <p:nvPr/>
        </p:nvSpPr>
        <p:spPr>
          <a:xfrm>
            <a:off x="8777002" y="4320941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8</a:t>
            </a:r>
            <a:endParaRPr kumimoji="1" lang="ja-US" altLang="en-US" sz="1200" dirty="0"/>
          </a:p>
        </p:txBody>
      </p:sp>
      <p:sp>
        <p:nvSpPr>
          <p:cNvPr id="163" name="テキスト ボックス 162">
            <a:extLst>
              <a:ext uri="{FF2B5EF4-FFF2-40B4-BE49-F238E27FC236}">
                <a16:creationId xmlns:a16="http://schemas.microsoft.com/office/drawing/2014/main" id="{60332737-CF05-FA43-282A-85015C207408}"/>
              </a:ext>
            </a:extLst>
          </p:cNvPr>
          <p:cNvSpPr txBox="1"/>
          <p:nvPr/>
        </p:nvSpPr>
        <p:spPr>
          <a:xfrm>
            <a:off x="9032958" y="4320941"/>
            <a:ext cx="4009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/>
              <a:t>0.5</a:t>
            </a:r>
            <a:endParaRPr kumimoji="1" lang="ja-US" altLang="en-US" sz="12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3245409-8B5B-5112-36EA-D5E37F732512}"/>
              </a:ext>
            </a:extLst>
          </p:cNvPr>
          <p:cNvSpPr txBox="1"/>
          <p:nvPr/>
        </p:nvSpPr>
        <p:spPr>
          <a:xfrm>
            <a:off x="42160" y="6469486"/>
            <a:ext cx="939558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kumimoji="1" lang="en-US" altLang="ja-US" sz="1400" b="1" dirty="0">
                <a:latin typeface="Palatino Linotype" panose="02040502050505030304" pitchFamily="18" charset="0"/>
              </a:rPr>
              <a:t>Supplementary Figure S4. </a:t>
            </a:r>
            <a:r>
              <a:rPr lang="en-US" altLang="ja-US" sz="1400" b="1" dirty="0">
                <a:effectLst/>
                <a:latin typeface="Palatino Linotype" panose="02040502050505030304" pitchFamily="18" charset="0"/>
              </a:rPr>
              <a:t>Uncropped Western blots corresponding to Figure 2D and E.</a:t>
            </a:r>
          </a:p>
        </p:txBody>
      </p:sp>
    </p:spTree>
    <p:extLst>
      <p:ext uri="{BB962C8B-B14F-4D97-AF65-F5344CB8AC3E}">
        <p14:creationId xmlns:p14="http://schemas.microsoft.com/office/powerpoint/2010/main" val="12237720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B5CAFB9-EA33-5657-9220-EEE97C6D55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B2451F4A-5C5C-A23D-5A4B-44E3529ED35A}"/>
              </a:ext>
            </a:extLst>
          </p:cNvPr>
          <p:cNvSpPr txBox="1"/>
          <p:nvPr/>
        </p:nvSpPr>
        <p:spPr>
          <a:xfrm>
            <a:off x="0" y="76951"/>
            <a:ext cx="16392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Figure 2F</a:t>
            </a:r>
            <a:endParaRPr kumimoji="1" lang="ja-US" altLang="en-US" b="1" dirty="0"/>
          </a:p>
        </p:txBody>
      </p:sp>
      <p:pic>
        <p:nvPicPr>
          <p:cNvPr id="3" name="図 2" descr="コンピューターの画面&#10;&#10;AI 生成コンテンツは誤りを含む可能性があります。">
            <a:extLst>
              <a:ext uri="{FF2B5EF4-FFF2-40B4-BE49-F238E27FC236}">
                <a16:creationId xmlns:a16="http://schemas.microsoft.com/office/drawing/2014/main" id="{1C723582-B710-7798-CC51-4EA7A9A4D7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13880"/>
            <a:ext cx="6146856" cy="4305973"/>
          </a:xfrm>
          <a:prstGeom prst="rect">
            <a:avLst/>
          </a:prstGeom>
        </p:spPr>
      </p:pic>
      <p:pic>
        <p:nvPicPr>
          <p:cNvPr id="6" name="図 5" descr="白黒の写真にテキストが書いてある｜｜｜ｐ&#10;&#10;AI 生成コンテンツは誤りを含む可能性があります。">
            <a:extLst>
              <a:ext uri="{FF2B5EF4-FFF2-40B4-BE49-F238E27FC236}">
                <a16:creationId xmlns:a16="http://schemas.microsoft.com/office/drawing/2014/main" id="{4CC3E253-1DD4-4F62-C4D8-F2AEF09C37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45144" y="1213880"/>
            <a:ext cx="6146856" cy="4305973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8139D24-96CB-E59B-5A58-4C59C645ED00}"/>
              </a:ext>
            </a:extLst>
          </p:cNvPr>
          <p:cNvSpPr txBox="1"/>
          <p:nvPr/>
        </p:nvSpPr>
        <p:spPr>
          <a:xfrm>
            <a:off x="78059" y="844548"/>
            <a:ext cx="9255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G401</a:t>
            </a:r>
            <a:endParaRPr kumimoji="1" lang="ja-US" altLang="en-US" b="1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2EAF8AF6-7371-D075-AA73-90C11703B46A}"/>
              </a:ext>
            </a:extLst>
          </p:cNvPr>
          <p:cNvSpPr txBox="1"/>
          <p:nvPr/>
        </p:nvSpPr>
        <p:spPr>
          <a:xfrm>
            <a:off x="6107826" y="844548"/>
            <a:ext cx="165342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b="1" dirty="0"/>
              <a:t>JMU-RTK-2</a:t>
            </a:r>
            <a:endParaRPr kumimoji="1" lang="ja-US" altLang="en-US" b="1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6747E1E-CF93-393B-2936-11F10D11D74B}"/>
              </a:ext>
            </a:extLst>
          </p:cNvPr>
          <p:cNvSpPr txBox="1"/>
          <p:nvPr/>
        </p:nvSpPr>
        <p:spPr>
          <a:xfrm>
            <a:off x="2940916" y="2474932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>
                <a:solidFill>
                  <a:schemeClr val="bg1"/>
                </a:solidFill>
              </a:rPr>
              <a:t>Unused</a:t>
            </a:r>
            <a:endParaRPr kumimoji="1" lang="ja-US" altLang="en-US" sz="1200" dirty="0">
              <a:solidFill>
                <a:schemeClr val="bg1"/>
              </a:solidFill>
            </a:endParaRP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05640780-128B-491A-DDE6-B1B46F2E30D8}"/>
              </a:ext>
            </a:extLst>
          </p:cNvPr>
          <p:cNvCxnSpPr>
            <a:cxnSpLocks/>
          </p:cNvCxnSpPr>
          <p:nvPr/>
        </p:nvCxnSpPr>
        <p:spPr>
          <a:xfrm>
            <a:off x="2946090" y="2751931"/>
            <a:ext cx="76231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3236A83-63F9-397B-B6FD-57CA497D8AF6}"/>
              </a:ext>
            </a:extLst>
          </p:cNvPr>
          <p:cNvSpPr txBox="1"/>
          <p:nvPr/>
        </p:nvSpPr>
        <p:spPr>
          <a:xfrm>
            <a:off x="8228667" y="2336432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>
                <a:solidFill>
                  <a:schemeClr val="bg1"/>
                </a:solidFill>
              </a:rPr>
              <a:t>Unused</a:t>
            </a:r>
            <a:endParaRPr kumimoji="1" lang="ja-US" altLang="en-US" sz="1200" dirty="0">
              <a:solidFill>
                <a:schemeClr val="bg1"/>
              </a:solidFill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E706DE7B-5C40-3AB9-58E6-4E0F102A4500}"/>
              </a:ext>
            </a:extLst>
          </p:cNvPr>
          <p:cNvCxnSpPr>
            <a:cxnSpLocks/>
          </p:cNvCxnSpPr>
          <p:nvPr/>
        </p:nvCxnSpPr>
        <p:spPr>
          <a:xfrm>
            <a:off x="8233841" y="2613431"/>
            <a:ext cx="76231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28782FDF-85E0-51DA-5BE6-F07D00995739}"/>
              </a:ext>
            </a:extLst>
          </p:cNvPr>
          <p:cNvCxnSpPr>
            <a:cxnSpLocks/>
          </p:cNvCxnSpPr>
          <p:nvPr/>
        </p:nvCxnSpPr>
        <p:spPr>
          <a:xfrm>
            <a:off x="2135374" y="2751930"/>
            <a:ext cx="76231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4FEC1BF6-0FAA-DF49-00CE-83645299823D}"/>
              </a:ext>
            </a:extLst>
          </p:cNvPr>
          <p:cNvSpPr txBox="1"/>
          <p:nvPr/>
        </p:nvSpPr>
        <p:spPr>
          <a:xfrm>
            <a:off x="2265834" y="2474931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>
                <a:solidFill>
                  <a:schemeClr val="bg1"/>
                </a:solidFill>
              </a:rPr>
              <a:t>G401</a:t>
            </a:r>
            <a:endParaRPr kumimoji="1" lang="ja-US" altLang="en-US" sz="1200" dirty="0">
              <a:solidFill>
                <a:schemeClr val="bg1"/>
              </a:solidFill>
            </a:endParaRPr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306DF584-2A27-8C48-AEB1-6E3A731C28B8}"/>
              </a:ext>
            </a:extLst>
          </p:cNvPr>
          <p:cNvCxnSpPr>
            <a:cxnSpLocks/>
          </p:cNvCxnSpPr>
          <p:nvPr/>
        </p:nvCxnSpPr>
        <p:spPr>
          <a:xfrm>
            <a:off x="9018912" y="2613431"/>
            <a:ext cx="762310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EBD313C-6F57-9A61-98C5-47DCFEE4B643}"/>
              </a:ext>
            </a:extLst>
          </p:cNvPr>
          <p:cNvSpPr txBox="1"/>
          <p:nvPr/>
        </p:nvSpPr>
        <p:spPr>
          <a:xfrm>
            <a:off x="9149372" y="2336432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>
                <a:solidFill>
                  <a:schemeClr val="bg1"/>
                </a:solidFill>
              </a:rPr>
              <a:t>JMU</a:t>
            </a:r>
            <a:endParaRPr kumimoji="1" lang="ja-US" altLang="en-US" sz="1200" dirty="0">
              <a:solidFill>
                <a:schemeClr val="bg1"/>
              </a:solidFill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9CFEA07-1FD8-9BE6-9491-79EFB8E07B62}"/>
              </a:ext>
            </a:extLst>
          </p:cNvPr>
          <p:cNvSpPr txBox="1"/>
          <p:nvPr/>
        </p:nvSpPr>
        <p:spPr>
          <a:xfrm>
            <a:off x="10316294" y="5597007"/>
            <a:ext cx="24423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dirty="0"/>
              <a:t>JMU: JMU-RTK-2</a:t>
            </a:r>
            <a:endParaRPr kumimoji="1" lang="ja-US" altLang="en-US" dirty="0"/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D6E5A109-A212-AA5C-15BB-7CD6AF657039}"/>
              </a:ext>
            </a:extLst>
          </p:cNvPr>
          <p:cNvCxnSpPr>
            <a:cxnSpLocks/>
          </p:cNvCxnSpPr>
          <p:nvPr/>
        </p:nvCxnSpPr>
        <p:spPr>
          <a:xfrm>
            <a:off x="3726683" y="3056731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D529F42C-FC31-D366-063B-2A0217CAA0CB}"/>
              </a:ext>
            </a:extLst>
          </p:cNvPr>
          <p:cNvCxnSpPr>
            <a:cxnSpLocks/>
          </p:cNvCxnSpPr>
          <p:nvPr/>
        </p:nvCxnSpPr>
        <p:spPr>
          <a:xfrm>
            <a:off x="3726683" y="3386931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15A6FE5-59C7-042E-B179-F2687B74E996}"/>
              </a:ext>
            </a:extLst>
          </p:cNvPr>
          <p:cNvSpPr txBox="1"/>
          <p:nvPr/>
        </p:nvSpPr>
        <p:spPr>
          <a:xfrm>
            <a:off x="3887953" y="2930931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 err="1">
                <a:solidFill>
                  <a:schemeClr val="bg1"/>
                </a:solidFill>
              </a:rPr>
              <a:t>unspliced</a:t>
            </a:r>
            <a:endParaRPr kumimoji="1" lang="ja-US" altLang="en-US" sz="1200" dirty="0">
              <a:solidFill>
                <a:schemeClr val="bg1"/>
              </a:solidFill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D76829B-3195-FE68-386A-0C46370668A1}"/>
              </a:ext>
            </a:extLst>
          </p:cNvPr>
          <p:cNvSpPr txBox="1"/>
          <p:nvPr/>
        </p:nvSpPr>
        <p:spPr>
          <a:xfrm>
            <a:off x="3887952" y="3248430"/>
            <a:ext cx="12867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>
                <a:solidFill>
                  <a:schemeClr val="bg1"/>
                </a:solidFill>
              </a:rPr>
              <a:t>spliced (302 bp)</a:t>
            </a:r>
            <a:endParaRPr kumimoji="1" lang="ja-US" altLang="en-US" sz="1200" dirty="0">
              <a:solidFill>
                <a:schemeClr val="bg1"/>
              </a:solidFill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4DB2A648-0CF0-CF00-BE98-2D6FC9BA55B0}"/>
              </a:ext>
            </a:extLst>
          </p:cNvPr>
          <p:cNvCxnSpPr>
            <a:cxnSpLocks/>
          </p:cNvCxnSpPr>
          <p:nvPr/>
        </p:nvCxnSpPr>
        <p:spPr>
          <a:xfrm>
            <a:off x="9860198" y="2877731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46CBE153-30C3-5DE8-E22B-1F5B771C4FAD}"/>
              </a:ext>
            </a:extLst>
          </p:cNvPr>
          <p:cNvCxnSpPr>
            <a:cxnSpLocks/>
          </p:cNvCxnSpPr>
          <p:nvPr/>
        </p:nvCxnSpPr>
        <p:spPr>
          <a:xfrm>
            <a:off x="9849251" y="3113614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C91C977C-3111-0E35-9789-BD296D9D54B8}"/>
              </a:ext>
            </a:extLst>
          </p:cNvPr>
          <p:cNvSpPr txBox="1"/>
          <p:nvPr/>
        </p:nvSpPr>
        <p:spPr>
          <a:xfrm>
            <a:off x="10021468" y="2751931"/>
            <a:ext cx="11669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 err="1">
                <a:solidFill>
                  <a:schemeClr val="bg1"/>
                </a:solidFill>
              </a:rPr>
              <a:t>unspliced</a:t>
            </a:r>
            <a:endParaRPr kumimoji="1" lang="ja-US" altLang="en-US" sz="1200" dirty="0">
              <a:solidFill>
                <a:schemeClr val="bg1"/>
              </a:solidFill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57CB651C-595A-B48D-765E-A69AFD02B597}"/>
              </a:ext>
            </a:extLst>
          </p:cNvPr>
          <p:cNvSpPr txBox="1"/>
          <p:nvPr/>
        </p:nvSpPr>
        <p:spPr>
          <a:xfrm>
            <a:off x="2972166" y="2721376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min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C4A1098B-F67F-8A2D-0151-DE532DCA17B4}"/>
              </a:ext>
            </a:extLst>
          </p:cNvPr>
          <p:cNvSpPr txBox="1"/>
          <p:nvPr/>
        </p:nvSpPr>
        <p:spPr>
          <a:xfrm>
            <a:off x="9783537" y="2625339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min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6E00C30D-CD22-CBF7-48E0-56D0E9517DE8}"/>
              </a:ext>
            </a:extLst>
          </p:cNvPr>
          <p:cNvSpPr txBox="1"/>
          <p:nvPr/>
        </p:nvSpPr>
        <p:spPr>
          <a:xfrm>
            <a:off x="2057138" y="2726132"/>
            <a:ext cx="2048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0701B51B-C855-39F7-619D-FC599B23D811}"/>
              </a:ext>
            </a:extLst>
          </p:cNvPr>
          <p:cNvSpPr txBox="1"/>
          <p:nvPr/>
        </p:nvSpPr>
        <p:spPr>
          <a:xfrm>
            <a:off x="2197700" y="2726132"/>
            <a:ext cx="3701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3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FDC2C4EA-4BFA-CD99-C18D-6034BDE91FA1}"/>
              </a:ext>
            </a:extLst>
          </p:cNvPr>
          <p:cNvSpPr txBox="1"/>
          <p:nvPr/>
        </p:nvSpPr>
        <p:spPr>
          <a:xfrm>
            <a:off x="2360257" y="2726132"/>
            <a:ext cx="3701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6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F86B610C-22BD-08E8-5FAD-5A6E0C5556B6}"/>
              </a:ext>
            </a:extLst>
          </p:cNvPr>
          <p:cNvSpPr txBox="1"/>
          <p:nvPr/>
        </p:nvSpPr>
        <p:spPr>
          <a:xfrm>
            <a:off x="2500937" y="2729139"/>
            <a:ext cx="431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18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FEB104B-2D16-9228-B594-1E01DBBFFAC2}"/>
              </a:ext>
            </a:extLst>
          </p:cNvPr>
          <p:cNvSpPr txBox="1"/>
          <p:nvPr/>
        </p:nvSpPr>
        <p:spPr>
          <a:xfrm>
            <a:off x="2715451" y="2726132"/>
            <a:ext cx="431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36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674066DC-8D76-ADA7-BBBA-728E19245D1E}"/>
              </a:ext>
            </a:extLst>
          </p:cNvPr>
          <p:cNvCxnSpPr>
            <a:cxnSpLocks/>
          </p:cNvCxnSpPr>
          <p:nvPr/>
        </p:nvCxnSpPr>
        <p:spPr>
          <a:xfrm>
            <a:off x="7833992" y="3255818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5C63B8E3-78EF-7038-280A-220E95FF4FFC}"/>
              </a:ext>
            </a:extLst>
          </p:cNvPr>
          <p:cNvCxnSpPr>
            <a:cxnSpLocks/>
          </p:cNvCxnSpPr>
          <p:nvPr/>
        </p:nvCxnSpPr>
        <p:spPr>
          <a:xfrm>
            <a:off x="7833992" y="3420918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57D8EC7-E54B-0144-FBFD-702ACDFA7FE0}"/>
              </a:ext>
            </a:extLst>
          </p:cNvPr>
          <p:cNvSpPr txBox="1"/>
          <p:nvPr/>
        </p:nvSpPr>
        <p:spPr>
          <a:xfrm>
            <a:off x="8913779" y="2629995"/>
            <a:ext cx="20489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D1797FC7-7A5E-52B5-14A3-13DE4725FB6C}"/>
              </a:ext>
            </a:extLst>
          </p:cNvPr>
          <p:cNvSpPr txBox="1"/>
          <p:nvPr/>
        </p:nvSpPr>
        <p:spPr>
          <a:xfrm>
            <a:off x="9027606" y="2637077"/>
            <a:ext cx="3701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3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A157E913-F686-56A3-30B8-AEC411585327}"/>
              </a:ext>
            </a:extLst>
          </p:cNvPr>
          <p:cNvSpPr txBox="1"/>
          <p:nvPr/>
        </p:nvSpPr>
        <p:spPr>
          <a:xfrm>
            <a:off x="9177004" y="2633517"/>
            <a:ext cx="3701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6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9F3343F3-581C-84AB-B452-C5381826B85E}"/>
              </a:ext>
            </a:extLst>
          </p:cNvPr>
          <p:cNvSpPr txBox="1"/>
          <p:nvPr/>
        </p:nvSpPr>
        <p:spPr>
          <a:xfrm>
            <a:off x="9310682" y="2633517"/>
            <a:ext cx="431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18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D14805BF-29E9-0C22-46D2-2E8BBB0D85C9}"/>
              </a:ext>
            </a:extLst>
          </p:cNvPr>
          <p:cNvSpPr txBox="1"/>
          <p:nvPr/>
        </p:nvSpPr>
        <p:spPr>
          <a:xfrm>
            <a:off x="9534988" y="2633517"/>
            <a:ext cx="4313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36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0AAD227C-5A7B-EC30-12A8-BC486D9D72AA}"/>
              </a:ext>
            </a:extLst>
          </p:cNvPr>
          <p:cNvCxnSpPr>
            <a:cxnSpLocks/>
          </p:cNvCxnSpPr>
          <p:nvPr/>
        </p:nvCxnSpPr>
        <p:spPr>
          <a:xfrm>
            <a:off x="7833992" y="3116118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1" name="直線コネクタ 50">
            <a:extLst>
              <a:ext uri="{FF2B5EF4-FFF2-40B4-BE49-F238E27FC236}">
                <a16:creationId xmlns:a16="http://schemas.microsoft.com/office/drawing/2014/main" id="{36079B86-33FA-FF83-D664-307D5A400989}"/>
              </a:ext>
            </a:extLst>
          </p:cNvPr>
          <p:cNvCxnSpPr>
            <a:cxnSpLocks/>
          </p:cNvCxnSpPr>
          <p:nvPr/>
        </p:nvCxnSpPr>
        <p:spPr>
          <a:xfrm>
            <a:off x="7833992" y="3027218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76460509-DAD4-64B8-7FE7-58BB9BE337E4}"/>
              </a:ext>
            </a:extLst>
          </p:cNvPr>
          <p:cNvCxnSpPr>
            <a:cxnSpLocks/>
          </p:cNvCxnSpPr>
          <p:nvPr/>
        </p:nvCxnSpPr>
        <p:spPr>
          <a:xfrm>
            <a:off x="7833992" y="2963718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3" name="直線コネクタ 52">
            <a:extLst>
              <a:ext uri="{FF2B5EF4-FFF2-40B4-BE49-F238E27FC236}">
                <a16:creationId xmlns:a16="http://schemas.microsoft.com/office/drawing/2014/main" id="{33412552-74C4-F4D4-A54E-1AFBD9B73ABF}"/>
              </a:ext>
            </a:extLst>
          </p:cNvPr>
          <p:cNvCxnSpPr>
            <a:cxnSpLocks/>
          </p:cNvCxnSpPr>
          <p:nvPr/>
        </p:nvCxnSpPr>
        <p:spPr>
          <a:xfrm>
            <a:off x="7833992" y="2874818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DCD7E160-6F3B-04AC-92FD-35F0C4E59B6B}"/>
              </a:ext>
            </a:extLst>
          </p:cNvPr>
          <p:cNvCxnSpPr>
            <a:cxnSpLocks/>
          </p:cNvCxnSpPr>
          <p:nvPr/>
        </p:nvCxnSpPr>
        <p:spPr>
          <a:xfrm>
            <a:off x="7833992" y="2785918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13386206-0DC7-2115-0B2A-F2891A51FB59}"/>
              </a:ext>
            </a:extLst>
          </p:cNvPr>
          <p:cNvCxnSpPr>
            <a:cxnSpLocks/>
          </p:cNvCxnSpPr>
          <p:nvPr/>
        </p:nvCxnSpPr>
        <p:spPr>
          <a:xfrm>
            <a:off x="7833992" y="2709718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21177192-9710-E4F8-A5EA-EB25525B262F}"/>
              </a:ext>
            </a:extLst>
          </p:cNvPr>
          <p:cNvSpPr txBox="1"/>
          <p:nvPr/>
        </p:nvSpPr>
        <p:spPr>
          <a:xfrm>
            <a:off x="7500701" y="2409721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bp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B76DE858-F8AF-4EA3-772D-2C2D821CC4B6}"/>
              </a:ext>
            </a:extLst>
          </p:cNvPr>
          <p:cNvSpPr txBox="1"/>
          <p:nvPr/>
        </p:nvSpPr>
        <p:spPr>
          <a:xfrm>
            <a:off x="7500701" y="3310507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75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A88D0049-2F8F-362D-1FB5-404BBB4C5981}"/>
              </a:ext>
            </a:extLst>
          </p:cNvPr>
          <p:cNvSpPr txBox="1"/>
          <p:nvPr/>
        </p:nvSpPr>
        <p:spPr>
          <a:xfrm>
            <a:off x="7448074" y="3145407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2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F4A0064A-2B56-9312-8C60-10357F1DB82C}"/>
              </a:ext>
            </a:extLst>
          </p:cNvPr>
          <p:cNvSpPr txBox="1"/>
          <p:nvPr/>
        </p:nvSpPr>
        <p:spPr>
          <a:xfrm>
            <a:off x="7448074" y="3018407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3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DB395CBB-8A95-49C1-6C53-6F735976888C}"/>
              </a:ext>
            </a:extLst>
          </p:cNvPr>
          <p:cNvSpPr txBox="1"/>
          <p:nvPr/>
        </p:nvSpPr>
        <p:spPr>
          <a:xfrm>
            <a:off x="7448074" y="2916807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4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F53C961F-5FA1-D458-8B75-EFF56E89C01D}"/>
              </a:ext>
            </a:extLst>
          </p:cNvPr>
          <p:cNvSpPr txBox="1"/>
          <p:nvPr/>
        </p:nvSpPr>
        <p:spPr>
          <a:xfrm>
            <a:off x="7448074" y="2827907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5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A046631C-22CA-6359-77B8-12C3D3AD3153}"/>
              </a:ext>
            </a:extLst>
          </p:cNvPr>
          <p:cNvSpPr txBox="1"/>
          <p:nvPr/>
        </p:nvSpPr>
        <p:spPr>
          <a:xfrm>
            <a:off x="7447713" y="2739007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7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36579074-E4CD-0939-B845-AE0BD3DE40C5}"/>
              </a:ext>
            </a:extLst>
          </p:cNvPr>
          <p:cNvSpPr txBox="1"/>
          <p:nvPr/>
        </p:nvSpPr>
        <p:spPr>
          <a:xfrm>
            <a:off x="7409324" y="2662285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10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3723DD8E-D2B1-1F54-1651-E14B781DA9F6}"/>
              </a:ext>
            </a:extLst>
          </p:cNvPr>
          <p:cNvSpPr txBox="1"/>
          <p:nvPr/>
        </p:nvSpPr>
        <p:spPr>
          <a:xfrm>
            <a:off x="7409324" y="2560685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15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cxnSp>
        <p:nvCxnSpPr>
          <p:cNvPr id="65" name="直線コネクタ 64">
            <a:extLst>
              <a:ext uri="{FF2B5EF4-FFF2-40B4-BE49-F238E27FC236}">
                <a16:creationId xmlns:a16="http://schemas.microsoft.com/office/drawing/2014/main" id="{88F28DE9-0EFD-0791-FDB1-187D06C214A7}"/>
              </a:ext>
            </a:extLst>
          </p:cNvPr>
          <p:cNvCxnSpPr>
            <a:cxnSpLocks/>
          </p:cNvCxnSpPr>
          <p:nvPr/>
        </p:nvCxnSpPr>
        <p:spPr>
          <a:xfrm>
            <a:off x="1814487" y="3555815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F013B0DD-6550-C72B-9AFA-CBFE2983084F}"/>
              </a:ext>
            </a:extLst>
          </p:cNvPr>
          <p:cNvCxnSpPr>
            <a:cxnSpLocks/>
          </p:cNvCxnSpPr>
          <p:nvPr/>
        </p:nvCxnSpPr>
        <p:spPr>
          <a:xfrm>
            <a:off x="1814487" y="3720915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直線コネクタ 66">
            <a:extLst>
              <a:ext uri="{FF2B5EF4-FFF2-40B4-BE49-F238E27FC236}">
                <a16:creationId xmlns:a16="http://schemas.microsoft.com/office/drawing/2014/main" id="{ED91A96E-82D9-D550-D497-321BD23AFF78}"/>
              </a:ext>
            </a:extLst>
          </p:cNvPr>
          <p:cNvCxnSpPr>
            <a:cxnSpLocks/>
          </p:cNvCxnSpPr>
          <p:nvPr/>
        </p:nvCxnSpPr>
        <p:spPr>
          <a:xfrm>
            <a:off x="1814487" y="3416115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8923784D-E3C5-A75E-1BE1-5B3BC38747F3}"/>
              </a:ext>
            </a:extLst>
          </p:cNvPr>
          <p:cNvCxnSpPr>
            <a:cxnSpLocks/>
          </p:cNvCxnSpPr>
          <p:nvPr/>
        </p:nvCxnSpPr>
        <p:spPr>
          <a:xfrm>
            <a:off x="1814487" y="3327215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9" name="直線コネクタ 68">
            <a:extLst>
              <a:ext uri="{FF2B5EF4-FFF2-40B4-BE49-F238E27FC236}">
                <a16:creationId xmlns:a16="http://schemas.microsoft.com/office/drawing/2014/main" id="{0EF7FCF4-A375-C70C-8FB2-F97824A330A0}"/>
              </a:ext>
            </a:extLst>
          </p:cNvPr>
          <p:cNvCxnSpPr>
            <a:cxnSpLocks/>
          </p:cNvCxnSpPr>
          <p:nvPr/>
        </p:nvCxnSpPr>
        <p:spPr>
          <a:xfrm>
            <a:off x="1814487" y="3263715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0" name="直線コネクタ 69">
            <a:extLst>
              <a:ext uri="{FF2B5EF4-FFF2-40B4-BE49-F238E27FC236}">
                <a16:creationId xmlns:a16="http://schemas.microsoft.com/office/drawing/2014/main" id="{0BC4F306-17CE-FCA8-1739-C2394D1ED1AE}"/>
              </a:ext>
            </a:extLst>
          </p:cNvPr>
          <p:cNvCxnSpPr>
            <a:cxnSpLocks/>
          </p:cNvCxnSpPr>
          <p:nvPr/>
        </p:nvCxnSpPr>
        <p:spPr>
          <a:xfrm>
            <a:off x="1814487" y="3174815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1" name="直線コネクタ 70">
            <a:extLst>
              <a:ext uri="{FF2B5EF4-FFF2-40B4-BE49-F238E27FC236}">
                <a16:creationId xmlns:a16="http://schemas.microsoft.com/office/drawing/2014/main" id="{4D0498F4-928C-6E9A-6DE2-982581BF658D}"/>
              </a:ext>
            </a:extLst>
          </p:cNvPr>
          <p:cNvCxnSpPr>
            <a:cxnSpLocks/>
          </p:cNvCxnSpPr>
          <p:nvPr/>
        </p:nvCxnSpPr>
        <p:spPr>
          <a:xfrm>
            <a:off x="1814487" y="3009715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52CC566D-F3D1-4831-F87C-212319CDB27F}"/>
              </a:ext>
            </a:extLst>
          </p:cNvPr>
          <p:cNvCxnSpPr>
            <a:cxnSpLocks/>
          </p:cNvCxnSpPr>
          <p:nvPr/>
        </p:nvCxnSpPr>
        <p:spPr>
          <a:xfrm>
            <a:off x="1814487" y="2908115"/>
            <a:ext cx="146817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405A2BD8-5D6F-0422-28F6-EDE0F9C52110}"/>
              </a:ext>
            </a:extLst>
          </p:cNvPr>
          <p:cNvSpPr txBox="1"/>
          <p:nvPr/>
        </p:nvSpPr>
        <p:spPr>
          <a:xfrm>
            <a:off x="1468713" y="2620995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bp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B0B6943B-C71B-7473-6260-BC4732E5DEF0}"/>
              </a:ext>
            </a:extLst>
          </p:cNvPr>
          <p:cNvSpPr txBox="1"/>
          <p:nvPr/>
        </p:nvSpPr>
        <p:spPr>
          <a:xfrm>
            <a:off x="1481196" y="3610504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75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EE24761-3B24-7C1C-ABA1-2A1DA423106A}"/>
              </a:ext>
            </a:extLst>
          </p:cNvPr>
          <p:cNvSpPr txBox="1"/>
          <p:nvPr/>
        </p:nvSpPr>
        <p:spPr>
          <a:xfrm>
            <a:off x="1428569" y="3445404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2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E92E9B1D-767E-576E-D6FC-9B8629BE1B32}"/>
              </a:ext>
            </a:extLst>
          </p:cNvPr>
          <p:cNvSpPr txBox="1"/>
          <p:nvPr/>
        </p:nvSpPr>
        <p:spPr>
          <a:xfrm>
            <a:off x="1428569" y="3318404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3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E287163C-1845-8C81-B9B9-57BBEB741253}"/>
              </a:ext>
            </a:extLst>
          </p:cNvPr>
          <p:cNvSpPr txBox="1"/>
          <p:nvPr/>
        </p:nvSpPr>
        <p:spPr>
          <a:xfrm>
            <a:off x="1428569" y="3216804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4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9C803A3D-39CA-4255-52B1-D55DDED60DCA}"/>
              </a:ext>
            </a:extLst>
          </p:cNvPr>
          <p:cNvSpPr txBox="1"/>
          <p:nvPr/>
        </p:nvSpPr>
        <p:spPr>
          <a:xfrm>
            <a:off x="1428569" y="3127904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5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AA1B7F7B-3746-8DA7-8224-908F0F93CFB9}"/>
              </a:ext>
            </a:extLst>
          </p:cNvPr>
          <p:cNvSpPr txBox="1"/>
          <p:nvPr/>
        </p:nvSpPr>
        <p:spPr>
          <a:xfrm>
            <a:off x="1426194" y="3026118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7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4557D7C0-BB70-4CB7-38A7-D0D5E70398CF}"/>
              </a:ext>
            </a:extLst>
          </p:cNvPr>
          <p:cNvSpPr txBox="1"/>
          <p:nvPr/>
        </p:nvSpPr>
        <p:spPr>
          <a:xfrm>
            <a:off x="1378421" y="2886604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10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F7BD245C-2CE8-503D-32E4-BCE098641B78}"/>
              </a:ext>
            </a:extLst>
          </p:cNvPr>
          <p:cNvSpPr txBox="1"/>
          <p:nvPr/>
        </p:nvSpPr>
        <p:spPr>
          <a:xfrm>
            <a:off x="1377336" y="2771450"/>
            <a:ext cx="116692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>
                <a:solidFill>
                  <a:schemeClr val="bg1"/>
                </a:solidFill>
              </a:rPr>
              <a:t>1500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BFC689A7-1872-4634-93FE-20ACEA3D6AB2}"/>
              </a:ext>
            </a:extLst>
          </p:cNvPr>
          <p:cNvSpPr txBox="1"/>
          <p:nvPr/>
        </p:nvSpPr>
        <p:spPr>
          <a:xfrm>
            <a:off x="10021468" y="2978633"/>
            <a:ext cx="12867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200" dirty="0">
                <a:solidFill>
                  <a:schemeClr val="bg1"/>
                </a:solidFill>
              </a:rPr>
              <a:t>spliced (302 bp)</a:t>
            </a:r>
            <a:endParaRPr kumimoji="1" lang="ja-US" altLang="en-US" sz="1200" dirty="0">
              <a:solidFill>
                <a:schemeClr val="bg1"/>
              </a:solidFill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91146679-E2EC-4E99-901D-60E0C4E890CC}"/>
              </a:ext>
            </a:extLst>
          </p:cNvPr>
          <p:cNvSpPr txBox="1"/>
          <p:nvPr/>
        </p:nvSpPr>
        <p:spPr>
          <a:xfrm>
            <a:off x="2102803" y="3395450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69DCD993-27AB-B24C-7F73-BE60DBED0BD0}"/>
              </a:ext>
            </a:extLst>
          </p:cNvPr>
          <p:cNvSpPr txBox="1"/>
          <p:nvPr/>
        </p:nvSpPr>
        <p:spPr>
          <a:xfrm>
            <a:off x="8913392" y="3359223"/>
            <a:ext cx="20647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 err="1">
                <a:solidFill>
                  <a:schemeClr val="bg1"/>
                </a:solidFill>
              </a:rPr>
              <a:t>Unspliced</a:t>
            </a:r>
            <a:r>
              <a:rPr kumimoji="1" lang="en-US" altLang="ja-US" sz="1000" dirty="0">
                <a:solidFill>
                  <a:schemeClr val="bg1"/>
                </a:solidFill>
              </a:rPr>
              <a:t>/Spliced ratio</a:t>
            </a:r>
            <a:endParaRPr kumimoji="1" lang="ja-US" altLang="en-US" sz="1000" dirty="0">
              <a:solidFill>
                <a:schemeClr val="bg1"/>
              </a:solidFill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542CFE49-CB04-18FA-AE4F-302BD19CC572}"/>
              </a:ext>
            </a:extLst>
          </p:cNvPr>
          <p:cNvSpPr txBox="1"/>
          <p:nvPr/>
        </p:nvSpPr>
        <p:spPr>
          <a:xfrm>
            <a:off x="2206903" y="3395450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0.9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9345264C-AA6C-97F9-7D1F-FB38EDEE570E}"/>
              </a:ext>
            </a:extLst>
          </p:cNvPr>
          <p:cNvSpPr txBox="1"/>
          <p:nvPr/>
        </p:nvSpPr>
        <p:spPr>
          <a:xfrm>
            <a:off x="2383748" y="3395255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0.8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2984A3EF-6F9E-B074-B0DA-61FAEC79E1B7}"/>
              </a:ext>
            </a:extLst>
          </p:cNvPr>
          <p:cNvSpPr txBox="1"/>
          <p:nvPr/>
        </p:nvSpPr>
        <p:spPr>
          <a:xfrm>
            <a:off x="2544258" y="3395255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0.7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3F6E2C3B-C2C2-BFE7-9841-386A7F70655F}"/>
              </a:ext>
            </a:extLst>
          </p:cNvPr>
          <p:cNvSpPr txBox="1"/>
          <p:nvPr/>
        </p:nvSpPr>
        <p:spPr>
          <a:xfrm>
            <a:off x="2706562" y="3395450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0.6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3E47EF86-C52F-3037-676E-435473786A26}"/>
              </a:ext>
            </a:extLst>
          </p:cNvPr>
          <p:cNvSpPr txBox="1"/>
          <p:nvPr/>
        </p:nvSpPr>
        <p:spPr>
          <a:xfrm>
            <a:off x="2105465" y="3080021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DDA53F39-CBA9-FEB1-ABC7-C959599ED6A6}"/>
              </a:ext>
            </a:extLst>
          </p:cNvPr>
          <p:cNvSpPr txBox="1"/>
          <p:nvPr/>
        </p:nvSpPr>
        <p:spPr>
          <a:xfrm>
            <a:off x="2265828" y="3080021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437B2C84-B447-D3FA-CEB3-6E847FEE3324}"/>
              </a:ext>
            </a:extLst>
          </p:cNvPr>
          <p:cNvSpPr txBox="1"/>
          <p:nvPr/>
        </p:nvSpPr>
        <p:spPr>
          <a:xfrm>
            <a:off x="2382786" y="3081951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0.8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E40F3902-4B6C-C577-40AA-70AC1232C292}"/>
              </a:ext>
            </a:extLst>
          </p:cNvPr>
          <p:cNvSpPr txBox="1"/>
          <p:nvPr/>
        </p:nvSpPr>
        <p:spPr>
          <a:xfrm>
            <a:off x="2543139" y="3081966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.1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6DE20318-9F09-E67C-5820-D510851BCD6A}"/>
              </a:ext>
            </a:extLst>
          </p:cNvPr>
          <p:cNvSpPr txBox="1"/>
          <p:nvPr/>
        </p:nvSpPr>
        <p:spPr>
          <a:xfrm>
            <a:off x="2732119" y="3089119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C6BB3C8F-306D-BDED-BF96-1396F20942A5}"/>
              </a:ext>
            </a:extLst>
          </p:cNvPr>
          <p:cNvSpPr txBox="1"/>
          <p:nvPr/>
        </p:nvSpPr>
        <p:spPr>
          <a:xfrm>
            <a:off x="8913392" y="3145407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B0FDE1F3-6B32-8DD4-2B36-03B312DCDA5C}"/>
              </a:ext>
            </a:extLst>
          </p:cNvPr>
          <p:cNvSpPr txBox="1"/>
          <p:nvPr/>
        </p:nvSpPr>
        <p:spPr>
          <a:xfrm>
            <a:off x="9017492" y="3145407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.1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1F6CA227-46D3-E3B9-1C9C-606FE2B3E026}"/>
              </a:ext>
            </a:extLst>
          </p:cNvPr>
          <p:cNvSpPr txBox="1"/>
          <p:nvPr/>
        </p:nvSpPr>
        <p:spPr>
          <a:xfrm>
            <a:off x="9194337" y="3145212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.1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4845CBCB-FA1B-4DAC-2038-17D9C5F206F8}"/>
              </a:ext>
            </a:extLst>
          </p:cNvPr>
          <p:cNvSpPr txBox="1"/>
          <p:nvPr/>
        </p:nvSpPr>
        <p:spPr>
          <a:xfrm>
            <a:off x="9354847" y="3145212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0.8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AEE17D7F-EB87-A406-8FDF-E1055718744E}"/>
              </a:ext>
            </a:extLst>
          </p:cNvPr>
          <p:cNvSpPr txBox="1"/>
          <p:nvPr/>
        </p:nvSpPr>
        <p:spPr>
          <a:xfrm>
            <a:off x="9517151" y="3145407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0.6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6A4F5462-06BD-44BF-17E9-366EC3FD7B6A}"/>
              </a:ext>
            </a:extLst>
          </p:cNvPr>
          <p:cNvSpPr txBox="1"/>
          <p:nvPr/>
        </p:nvSpPr>
        <p:spPr>
          <a:xfrm>
            <a:off x="8914140" y="2883298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5EEA256A-90DA-4D6B-FE76-DC65206B1A56}"/>
              </a:ext>
            </a:extLst>
          </p:cNvPr>
          <p:cNvSpPr txBox="1"/>
          <p:nvPr/>
        </p:nvSpPr>
        <p:spPr>
          <a:xfrm>
            <a:off x="9021584" y="2873778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.1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9C39FB2F-4C7C-DEED-977C-44AF448CECC9}"/>
              </a:ext>
            </a:extLst>
          </p:cNvPr>
          <p:cNvSpPr txBox="1"/>
          <p:nvPr/>
        </p:nvSpPr>
        <p:spPr>
          <a:xfrm>
            <a:off x="9188245" y="2883298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.1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806731CA-ED8F-9D98-3501-6A851192F2FC}"/>
              </a:ext>
            </a:extLst>
          </p:cNvPr>
          <p:cNvSpPr txBox="1"/>
          <p:nvPr/>
        </p:nvSpPr>
        <p:spPr>
          <a:xfrm>
            <a:off x="9338270" y="2883298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.3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665FAE44-2F22-6727-E379-39C324E40230}"/>
              </a:ext>
            </a:extLst>
          </p:cNvPr>
          <p:cNvSpPr txBox="1"/>
          <p:nvPr/>
        </p:nvSpPr>
        <p:spPr>
          <a:xfrm>
            <a:off x="9517181" y="2884005"/>
            <a:ext cx="4313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800" dirty="0">
                <a:solidFill>
                  <a:schemeClr val="bg1"/>
                </a:solidFill>
              </a:rPr>
              <a:t>1.4</a:t>
            </a:r>
            <a:endParaRPr kumimoji="1" lang="ja-US" altLang="en-US" sz="800" dirty="0">
              <a:solidFill>
                <a:schemeClr val="bg1"/>
              </a:solidFill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5AA2B0DA-C363-B2CC-B540-370BF5C61D78}"/>
              </a:ext>
            </a:extLst>
          </p:cNvPr>
          <p:cNvSpPr txBox="1"/>
          <p:nvPr/>
        </p:nvSpPr>
        <p:spPr>
          <a:xfrm>
            <a:off x="78059" y="6363861"/>
            <a:ext cx="9395589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buNone/>
            </a:pPr>
            <a:r>
              <a:rPr kumimoji="1" lang="en-US" altLang="ja-US" sz="1400" b="1" dirty="0">
                <a:latin typeface="Palatino Linotype" panose="02040502050505030304" pitchFamily="18" charset="0"/>
              </a:rPr>
              <a:t>Supplementary Figure S5. </a:t>
            </a:r>
            <a:r>
              <a:rPr lang="en-US" altLang="ja-US" sz="1400" b="1" dirty="0">
                <a:latin typeface="Palatino Linotype" panose="02040502050505030304" pitchFamily="18" charset="0"/>
              </a:rPr>
              <a:t>Uncropped RT-PCR gels corresponding to </a:t>
            </a:r>
            <a:r>
              <a:rPr lang="en-US" altLang="ja-US" sz="1400" b="1">
                <a:latin typeface="Palatino Linotype" panose="02040502050505030304" pitchFamily="18" charset="0"/>
              </a:rPr>
              <a:t>Figure 2F. </a:t>
            </a:r>
            <a:endParaRPr lang="en-US" altLang="ja-US" sz="1400" b="1" dirty="0">
              <a:effectLst/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82264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2</TotalTime>
  <Words>511</Words>
  <Application>Microsoft Office PowerPoint</Application>
  <PresentationFormat>Widescreen</PresentationFormat>
  <Paragraphs>265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ptos</vt:lpstr>
      <vt:lpstr>Aptos Display</vt:lpstr>
      <vt:lpstr>Arial</vt:lpstr>
      <vt:lpstr>Palatino Linotype</vt:lpstr>
      <vt:lpstr>Office テーマ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ki Murakami</dc:creator>
  <cp:lastModifiedBy>MDPI</cp:lastModifiedBy>
  <cp:revision>23</cp:revision>
  <dcterms:created xsi:type="dcterms:W3CDTF">2025-11-16T02:52:01Z</dcterms:created>
  <dcterms:modified xsi:type="dcterms:W3CDTF">2026-01-12T09:44:57Z</dcterms:modified>
</cp:coreProperties>
</file>